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_rels/notesSlide3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notesMasterIdLst>
    <p:notesMasterId r:id="rId4"/>
  </p:notesMasterIdLst>
  <p:sldIdLst>
    <p:sldId id="256" r:id="rId5"/>
    <p:sldId id="257" r:id="rId6"/>
    <p:sldId id="258" r:id="rId7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 type="dt" idx="7"/>
          </p:nvPr>
        </p:nvSpPr>
        <p:spPr>
          <a:xfrm>
            <a:off x="3849840" y="-36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PlaceHolder 3"/>
          <p:cNvSpPr>
            <a:spLocks noGrp="1"/>
          </p:cNvSpPr>
          <p:nvPr>
            <p:ph type="sldImg"/>
          </p:nvPr>
        </p:nvSpPr>
        <p:spPr>
          <a:xfrm>
            <a:off x="1164960" y="1240920"/>
            <a:ext cx="4467240" cy="3349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2160" rIns="92160" tIns="46080" bIns="4608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6" name="PlaceHolder 4"/>
          <p:cNvSpPr>
            <a:spLocks noGrp="1"/>
          </p:cNvSpPr>
          <p:nvPr>
            <p:ph type="body"/>
          </p:nvPr>
        </p:nvSpPr>
        <p:spPr>
          <a:xfrm>
            <a:off x="679320" y="4776480"/>
            <a:ext cx="5438880" cy="390852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PlaceHolder 5"/>
          <p:cNvSpPr>
            <a:spLocks noGrp="1"/>
          </p:cNvSpPr>
          <p:nvPr>
            <p:ph type="ftr" idx="8"/>
          </p:nvPr>
        </p:nvSpPr>
        <p:spPr>
          <a:xfrm>
            <a:off x="0" y="942768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PlaceHolder 6"/>
          <p:cNvSpPr>
            <a:spLocks noGrp="1"/>
          </p:cNvSpPr>
          <p:nvPr>
            <p:ph type="sldNum" idx="9"/>
          </p:nvPr>
        </p:nvSpPr>
        <p:spPr>
          <a:xfrm>
            <a:off x="3849840" y="942768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2160" rIns="92160" tIns="46080" bIns="4608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809C12-55C8-4853-B3C1-172D65888883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2" name="PlaceHolder 1"/>
          <p:cNvSpPr>
            <a:spLocks noGrp="1"/>
          </p:cNvSpPr>
          <p:nvPr>
            <p:ph type="sldImg"/>
          </p:nvPr>
        </p:nvSpPr>
        <p:spPr>
          <a:xfrm>
            <a:off x="1165320" y="1241280"/>
            <a:ext cx="4467240" cy="3349800"/>
          </a:xfrm>
          <a:prstGeom prst="rect">
            <a:avLst/>
          </a:prstGeom>
          <a:ln w="0">
            <a:noFill/>
          </a:ln>
        </p:spPr>
      </p:sp>
      <p:sp>
        <p:nvSpPr>
          <p:cNvPr id="393" name="PlaceHolder 2"/>
          <p:cNvSpPr>
            <a:spLocks noGrp="1"/>
          </p:cNvSpPr>
          <p:nvPr>
            <p:ph type="body"/>
          </p:nvPr>
        </p:nvSpPr>
        <p:spPr>
          <a:xfrm>
            <a:off x="679320" y="4776480"/>
            <a:ext cx="5438880" cy="390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スライド番号プレースホルダー 3"/>
          <p:cNvSpPr/>
          <p:nvPr/>
        </p:nvSpPr>
        <p:spPr>
          <a:xfrm>
            <a:off x="3849840" y="9428040"/>
            <a:ext cx="2946240" cy="49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160" rIns="92160" tIns="46080" bIns="4608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FED9D6D-B2EA-4B5D-AB7B-C970FF586F72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sldImg"/>
          </p:nvPr>
        </p:nvSpPr>
        <p:spPr>
          <a:xfrm>
            <a:off x="1165320" y="1241280"/>
            <a:ext cx="4467240" cy="3349800"/>
          </a:xfrm>
          <a:prstGeom prst="rect">
            <a:avLst/>
          </a:prstGeom>
          <a:ln w="0">
            <a:noFill/>
          </a:ln>
        </p:spPr>
      </p:sp>
      <p:sp>
        <p:nvSpPr>
          <p:cNvPr id="396" name="PlaceHolder 2"/>
          <p:cNvSpPr>
            <a:spLocks noGrp="1"/>
          </p:cNvSpPr>
          <p:nvPr>
            <p:ph type="body"/>
          </p:nvPr>
        </p:nvSpPr>
        <p:spPr>
          <a:xfrm>
            <a:off x="679320" y="4776480"/>
            <a:ext cx="5438880" cy="390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スライド番号プレースホルダー 3"/>
          <p:cNvSpPr/>
          <p:nvPr/>
        </p:nvSpPr>
        <p:spPr>
          <a:xfrm>
            <a:off x="3849840" y="9428040"/>
            <a:ext cx="2946240" cy="49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160" rIns="92160" tIns="46080" bIns="4608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1ADF81-44F0-4673-8D42-65616B11855E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1F28B0-B0D9-4B39-BEAC-10BF1A42AB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117B5D-2B44-4498-9787-247E3AF4D2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CB92A3-404A-4703-98A5-1099AFBCBA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E3AE5B-ABB7-4CEE-A98E-014CDF9493D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BD8F951-5C9A-4776-BC1A-47E19FF266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12FEE77-C933-4342-991B-5D9C0A183E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B649617-FFF3-4B46-894F-BB039417E6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685323E-BFEF-485C-A794-BD4307E88D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DC6C999-EBB0-40A4-AC56-571732F37C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262D7FA-5817-476A-8543-5C697E3852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5BBF1AE-4DE8-4585-86F7-A105127F63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42247A-A2EF-414A-9DD4-6CF9512AAD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647717D-EAE0-457E-A605-A90300FAFC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65B606F-1CBD-45A5-A864-FE72FA5162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FA8CD0D-221A-4375-8C18-282FC1F5C3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965F7E8-48FF-4DBA-81A2-DDACA21414F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DB3BBD0-FCAB-48C5-8466-1514532922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0B6CD1-DFFB-4118-B673-505A2897DC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6A7D3B-7D44-48E5-88B8-03743CFBBE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81E3AD-76A2-4378-B602-793FC06AA6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1CB72-7AB5-473C-A6F8-4B5CC2D9EA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8DF152-0788-4E45-A978-44176E7297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67CEF0-E943-485D-A9D0-76EDE159D5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EBAB07-594A-4A55-9639-EDA7DF7953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a6b727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a6b727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a6b727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25322E-AE1C-4E08-BB22-A09F6BCB4D7E}" type="slidenum">
              <a:rPr b="0" lang="ja-JP" sz="900" spc="-1" strike="noStrike">
                <a:solidFill>
                  <a:srgbClr val="a6b727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E53FF1-19E9-4CB0-A28E-B8E8F1F49A11}" type="slidenum">
              <a:rPr b="0" lang="ja-JP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Text Box 70"/>
          <p:cNvSpPr/>
          <p:nvPr/>
        </p:nvSpPr>
        <p:spPr>
          <a:xfrm>
            <a:off x="176040" y="3164040"/>
            <a:ext cx="172584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Unilateral-onse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 Box 70"/>
          <p:cNvSpPr/>
          <p:nvPr/>
        </p:nvSpPr>
        <p:spPr>
          <a:xfrm>
            <a:off x="1440000" y="4746600"/>
            <a:ext cx="1347480" cy="45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Local therap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 Box 70"/>
          <p:cNvSpPr/>
          <p:nvPr/>
        </p:nvSpPr>
        <p:spPr>
          <a:xfrm>
            <a:off x="1457280" y="795240"/>
            <a:ext cx="1187640" cy="459000"/>
          </a:xfrm>
          <a:prstGeom prst="rect">
            <a:avLst/>
          </a:prstGeom>
          <a:solidFill>
            <a:srgbClr val="ffff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Enucleat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92" name="直線矢印コネクタ 12"/>
          <p:cNvCxnSpPr>
            <a:endCxn id="93" idx="3"/>
          </p:cNvCxnSpPr>
          <p:nvPr/>
        </p:nvCxnSpPr>
        <p:spPr>
          <a:xfrm flipV="1">
            <a:off x="601200" y="1050840"/>
            <a:ext cx="731520" cy="21862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4" name="直線矢印コネクタ 14"/>
          <p:cNvCxnSpPr>
            <a:stCxn id="91" idx="3"/>
          </p:cNvCxnSpPr>
          <p:nvPr/>
        </p:nvCxnSpPr>
        <p:spPr>
          <a:xfrm flipV="1">
            <a:off x="2644920" y="977040"/>
            <a:ext cx="4661280" cy="478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5" name="直線矢印コネクタ 15"/>
          <p:cNvCxnSpPr>
            <a:stCxn id="91" idx="3"/>
            <a:endCxn id="96" idx="1"/>
          </p:cNvCxnSpPr>
          <p:nvPr/>
        </p:nvCxnSpPr>
        <p:spPr>
          <a:xfrm>
            <a:off x="2644920" y="1024560"/>
            <a:ext cx="1974960" cy="32040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7" name="直線矢印コネクタ 16"/>
          <p:cNvCxnSpPr>
            <a:stCxn id="90" idx="3"/>
            <a:endCxn id="98" idx="1"/>
          </p:cNvCxnSpPr>
          <p:nvPr/>
        </p:nvCxnSpPr>
        <p:spPr>
          <a:xfrm>
            <a:off x="2787480" y="4975920"/>
            <a:ext cx="1445040" cy="11448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9" name="直線矢印コネクタ 17"/>
          <p:cNvCxnSpPr>
            <a:stCxn id="90" idx="3"/>
            <a:endCxn id="100" idx="1"/>
          </p:cNvCxnSpPr>
          <p:nvPr/>
        </p:nvCxnSpPr>
        <p:spPr>
          <a:xfrm flipV="1">
            <a:off x="2787480" y="4961520"/>
            <a:ext cx="1462680" cy="147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1" name="直線矢印コネクタ 18"/>
          <p:cNvCxnSpPr>
            <a:stCxn id="102" idx="2"/>
            <a:endCxn id="90" idx="1"/>
          </p:cNvCxnSpPr>
          <p:nvPr/>
        </p:nvCxnSpPr>
        <p:spPr>
          <a:xfrm>
            <a:off x="618120" y="3932280"/>
            <a:ext cx="822240" cy="10440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3" name="直線矢印コネクタ 20"/>
          <p:cNvCxnSpPr/>
          <p:nvPr/>
        </p:nvCxnSpPr>
        <p:spPr>
          <a:xfrm>
            <a:off x="4365360" y="2579400"/>
            <a:ext cx="279468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4" name="直線矢印コネクタ 23"/>
          <p:cNvCxnSpPr/>
          <p:nvPr/>
        </p:nvCxnSpPr>
        <p:spPr>
          <a:xfrm>
            <a:off x="5254200" y="4936680"/>
            <a:ext cx="195804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8" name="Text Box 70"/>
          <p:cNvSpPr/>
          <p:nvPr/>
        </p:nvSpPr>
        <p:spPr>
          <a:xfrm>
            <a:off x="4232160" y="5891040"/>
            <a:ext cx="522360" cy="459000"/>
          </a:xfrm>
          <a:prstGeom prst="rect">
            <a:avLst/>
          </a:prstGeom>
          <a:solidFill>
            <a:srgbClr val="d9d9d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R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05" name="直線矢印コネクタ 26"/>
          <p:cNvCxnSpPr>
            <a:stCxn id="91" idx="3"/>
          </p:cNvCxnSpPr>
          <p:nvPr/>
        </p:nvCxnSpPr>
        <p:spPr>
          <a:xfrm>
            <a:off x="2644920" y="1024560"/>
            <a:ext cx="2028960" cy="10940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02" name="テキスト ボックス 33"/>
          <p:cNvSpPr/>
          <p:nvPr/>
        </p:nvSpPr>
        <p:spPr>
          <a:xfrm>
            <a:off x="412200" y="356400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7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06" name="直線矢印コネクタ 35"/>
          <p:cNvCxnSpPr/>
          <p:nvPr/>
        </p:nvCxnSpPr>
        <p:spPr>
          <a:xfrm flipV="1">
            <a:off x="5109840" y="4249080"/>
            <a:ext cx="246600" cy="68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7" name="直線矢印コネクタ 36"/>
          <p:cNvCxnSpPr/>
          <p:nvPr/>
        </p:nvCxnSpPr>
        <p:spPr>
          <a:xfrm>
            <a:off x="6719760" y="4255560"/>
            <a:ext cx="486720" cy="39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8" name="直線矢印コネクタ 38"/>
          <p:cNvCxnSpPr/>
          <p:nvPr/>
        </p:nvCxnSpPr>
        <p:spPr>
          <a:xfrm flipV="1">
            <a:off x="5403600" y="6108480"/>
            <a:ext cx="14652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9" name="直線矢印コネクタ 40"/>
          <p:cNvCxnSpPr/>
          <p:nvPr/>
        </p:nvCxnSpPr>
        <p:spPr>
          <a:xfrm>
            <a:off x="6662880" y="2133360"/>
            <a:ext cx="4975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6" name="Text Box 70"/>
          <p:cNvSpPr/>
          <p:nvPr/>
        </p:nvSpPr>
        <p:spPr>
          <a:xfrm>
            <a:off x="4619520" y="3998880"/>
            <a:ext cx="582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10" name="直線矢印コネクタ 42"/>
          <p:cNvCxnSpPr/>
          <p:nvPr/>
        </p:nvCxnSpPr>
        <p:spPr>
          <a:xfrm flipV="1">
            <a:off x="5959080" y="3687120"/>
            <a:ext cx="1236960" cy="68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11" name="直線矢印コネクタ 43"/>
          <p:cNvCxnSpPr/>
          <p:nvPr/>
        </p:nvCxnSpPr>
        <p:spPr>
          <a:xfrm flipV="1">
            <a:off x="5656320" y="3048840"/>
            <a:ext cx="15055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12" name="直線矢印コネクタ 44"/>
          <p:cNvCxnSpPr/>
          <p:nvPr/>
        </p:nvCxnSpPr>
        <p:spPr>
          <a:xfrm flipV="1">
            <a:off x="4760640" y="6087240"/>
            <a:ext cx="146520" cy="2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13" name="Text Box 70"/>
          <p:cNvSpPr/>
          <p:nvPr/>
        </p:nvSpPr>
        <p:spPr>
          <a:xfrm>
            <a:off x="4890960" y="5883120"/>
            <a:ext cx="468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14" name="直線矢印コネクタ 47"/>
          <p:cNvCxnSpPr/>
          <p:nvPr/>
        </p:nvCxnSpPr>
        <p:spPr>
          <a:xfrm flipV="1">
            <a:off x="6675480" y="6106320"/>
            <a:ext cx="565920" cy="54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15" name="Text Box 70"/>
          <p:cNvSpPr/>
          <p:nvPr/>
        </p:nvSpPr>
        <p:spPr>
          <a:xfrm>
            <a:off x="5535720" y="5297400"/>
            <a:ext cx="1184040" cy="45900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Enucleat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16" name="直線矢印コネクタ 49"/>
          <p:cNvCxnSpPr/>
          <p:nvPr/>
        </p:nvCxnSpPr>
        <p:spPr>
          <a:xfrm flipV="1">
            <a:off x="5403600" y="5527440"/>
            <a:ext cx="14652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17" name="Text Box 70"/>
          <p:cNvSpPr/>
          <p:nvPr/>
        </p:nvSpPr>
        <p:spPr>
          <a:xfrm>
            <a:off x="4890960" y="5300640"/>
            <a:ext cx="468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18" name="直線矢印コネクタ 51"/>
          <p:cNvCxnSpPr/>
          <p:nvPr/>
        </p:nvCxnSpPr>
        <p:spPr>
          <a:xfrm flipV="1">
            <a:off x="6675480" y="5527440"/>
            <a:ext cx="56736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19" name="直線矢印コネクタ 52"/>
          <p:cNvCxnSpPr>
            <a:endCxn id="117" idx="1"/>
          </p:cNvCxnSpPr>
          <p:nvPr/>
        </p:nvCxnSpPr>
        <p:spPr>
          <a:xfrm>
            <a:off x="4743360" y="5145120"/>
            <a:ext cx="147960" cy="3852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3" name="テキスト ボックス 53"/>
          <p:cNvSpPr/>
          <p:nvPr/>
        </p:nvSpPr>
        <p:spPr>
          <a:xfrm>
            <a:off x="920160" y="86688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69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テキスト ボックス 55"/>
          <p:cNvSpPr/>
          <p:nvPr/>
        </p:nvSpPr>
        <p:spPr>
          <a:xfrm>
            <a:off x="2652840" y="228276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1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テキスト ボックス 56"/>
          <p:cNvSpPr/>
          <p:nvPr/>
        </p:nvSpPr>
        <p:spPr>
          <a:xfrm>
            <a:off x="8016120" y="80496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50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テキスト ボックス 57"/>
          <p:cNvSpPr/>
          <p:nvPr/>
        </p:nvSpPr>
        <p:spPr>
          <a:xfrm>
            <a:off x="8051040" y="138600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テキスト ボックス 58"/>
          <p:cNvSpPr/>
          <p:nvPr/>
        </p:nvSpPr>
        <p:spPr>
          <a:xfrm>
            <a:off x="8074080" y="1973160"/>
            <a:ext cx="35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1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テキスト ボックス 59"/>
          <p:cNvSpPr/>
          <p:nvPr/>
        </p:nvSpPr>
        <p:spPr>
          <a:xfrm>
            <a:off x="8032680" y="241632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テキスト ボックス 60"/>
          <p:cNvSpPr/>
          <p:nvPr/>
        </p:nvSpPr>
        <p:spPr>
          <a:xfrm>
            <a:off x="8024760" y="403056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テキスト ボックス 61"/>
          <p:cNvSpPr/>
          <p:nvPr/>
        </p:nvSpPr>
        <p:spPr>
          <a:xfrm>
            <a:off x="8024760" y="354492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テキスト ボックス 62"/>
          <p:cNvSpPr/>
          <p:nvPr/>
        </p:nvSpPr>
        <p:spPr>
          <a:xfrm>
            <a:off x="7992360" y="289260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1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テキスト ボックス 63"/>
          <p:cNvSpPr/>
          <p:nvPr/>
        </p:nvSpPr>
        <p:spPr>
          <a:xfrm>
            <a:off x="8015400" y="591804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テキスト ボックス 64"/>
          <p:cNvSpPr/>
          <p:nvPr/>
        </p:nvSpPr>
        <p:spPr>
          <a:xfrm>
            <a:off x="6304680" y="476712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テキスト ボックス 65"/>
          <p:cNvSpPr/>
          <p:nvPr/>
        </p:nvSpPr>
        <p:spPr>
          <a:xfrm>
            <a:off x="8015400" y="536724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テキスト ボックス 66"/>
          <p:cNvSpPr/>
          <p:nvPr/>
        </p:nvSpPr>
        <p:spPr>
          <a:xfrm>
            <a:off x="7299360" y="804960"/>
            <a:ext cx="682560" cy="36828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テキスト ボックス 67"/>
          <p:cNvSpPr/>
          <p:nvPr/>
        </p:nvSpPr>
        <p:spPr>
          <a:xfrm>
            <a:off x="1050840" y="479124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テキスト ボックス 68"/>
          <p:cNvSpPr/>
          <p:nvPr/>
        </p:nvSpPr>
        <p:spPr>
          <a:xfrm>
            <a:off x="7284960" y="1374840"/>
            <a:ext cx="682560" cy="36828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テキスト ボックス 69"/>
          <p:cNvSpPr/>
          <p:nvPr/>
        </p:nvSpPr>
        <p:spPr>
          <a:xfrm>
            <a:off x="7299360" y="1936800"/>
            <a:ext cx="682560" cy="368280"/>
          </a:xfrm>
          <a:prstGeom prst="rect">
            <a:avLst/>
          </a:prstGeom>
          <a:solidFill>
            <a:srgbClr val="000000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Calibri"/>
                <a:ea typeface="Times New Roman"/>
              </a:rPr>
              <a:t>Dea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テキスト ボックス 70"/>
          <p:cNvSpPr/>
          <p:nvPr/>
        </p:nvSpPr>
        <p:spPr>
          <a:xfrm>
            <a:off x="7284960" y="2405160"/>
            <a:ext cx="682560" cy="368280"/>
          </a:xfrm>
          <a:prstGeom prst="rect">
            <a:avLst/>
          </a:prstGeom>
          <a:solidFill>
            <a:srgbClr val="ffff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テキスト ボックス 71"/>
          <p:cNvSpPr/>
          <p:nvPr/>
        </p:nvSpPr>
        <p:spPr>
          <a:xfrm>
            <a:off x="7269120" y="2855880"/>
            <a:ext cx="682560" cy="36828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テキスト ボックス 72"/>
          <p:cNvSpPr/>
          <p:nvPr/>
        </p:nvSpPr>
        <p:spPr>
          <a:xfrm>
            <a:off x="7284960" y="3538440"/>
            <a:ext cx="682560" cy="36828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 Box 70"/>
          <p:cNvSpPr/>
          <p:nvPr/>
        </p:nvSpPr>
        <p:spPr>
          <a:xfrm>
            <a:off x="5505480" y="1308240"/>
            <a:ext cx="1046160" cy="45900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Chemo Tx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 Box 70"/>
          <p:cNvSpPr/>
          <p:nvPr/>
        </p:nvSpPr>
        <p:spPr>
          <a:xfrm>
            <a:off x="4249800" y="4732200"/>
            <a:ext cx="1044360" cy="459000"/>
          </a:xfrm>
          <a:prstGeom prst="rect">
            <a:avLst/>
          </a:prstGeom>
          <a:solidFill>
            <a:srgbClr val="d9d9d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Chemo Tx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 Box 70"/>
          <p:cNvSpPr/>
          <p:nvPr/>
        </p:nvSpPr>
        <p:spPr>
          <a:xfrm>
            <a:off x="4649760" y="2813040"/>
            <a:ext cx="1044720" cy="45900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Chemo Tx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 Box 70"/>
          <p:cNvSpPr/>
          <p:nvPr/>
        </p:nvSpPr>
        <p:spPr>
          <a:xfrm>
            <a:off x="4645080" y="3495600"/>
            <a:ext cx="1325520" cy="82404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RT+Chemo Tx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 Box 70"/>
          <p:cNvSpPr/>
          <p:nvPr/>
        </p:nvSpPr>
        <p:spPr>
          <a:xfrm>
            <a:off x="5372280" y="4037040"/>
            <a:ext cx="1325520" cy="82404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RT+Chemo Tx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42" name="直線矢印コネクタ 93"/>
          <p:cNvCxnSpPr/>
          <p:nvPr/>
        </p:nvCxnSpPr>
        <p:spPr>
          <a:xfrm flipV="1">
            <a:off x="5022720" y="2129760"/>
            <a:ext cx="246960" cy="68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43" name="Text Box 70"/>
          <p:cNvSpPr/>
          <p:nvPr/>
        </p:nvSpPr>
        <p:spPr>
          <a:xfrm>
            <a:off x="4567320" y="1881360"/>
            <a:ext cx="582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 Box 70"/>
          <p:cNvSpPr/>
          <p:nvPr/>
        </p:nvSpPr>
        <p:spPr>
          <a:xfrm>
            <a:off x="5316480" y="1928880"/>
            <a:ext cx="1325520" cy="82404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RT+Chemo Tx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テキスト ボックス 97"/>
          <p:cNvSpPr/>
          <p:nvPr/>
        </p:nvSpPr>
        <p:spPr>
          <a:xfrm>
            <a:off x="7284960" y="4038480"/>
            <a:ext cx="682560" cy="36828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テキスト ボックス 98"/>
          <p:cNvSpPr/>
          <p:nvPr/>
        </p:nvSpPr>
        <p:spPr>
          <a:xfrm>
            <a:off x="7307280" y="4743360"/>
            <a:ext cx="684360" cy="368280"/>
          </a:xfrm>
          <a:prstGeom prst="rect">
            <a:avLst/>
          </a:prstGeom>
          <a:solidFill>
            <a:srgbClr val="d9d9d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テキスト ボックス 99"/>
          <p:cNvSpPr/>
          <p:nvPr/>
        </p:nvSpPr>
        <p:spPr>
          <a:xfrm>
            <a:off x="7299360" y="5334120"/>
            <a:ext cx="682560" cy="36828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 Box 70"/>
          <p:cNvSpPr/>
          <p:nvPr/>
        </p:nvSpPr>
        <p:spPr>
          <a:xfrm>
            <a:off x="5545080" y="5899320"/>
            <a:ext cx="1182600" cy="45900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Enucleat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テキスト ボックス 101"/>
          <p:cNvSpPr/>
          <p:nvPr/>
        </p:nvSpPr>
        <p:spPr>
          <a:xfrm>
            <a:off x="7307280" y="5911920"/>
            <a:ext cx="684360" cy="36828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50" name="直線矢印コネクタ 29"/>
          <p:cNvCxnSpPr>
            <a:stCxn id="91" idx="3"/>
            <a:endCxn id="138" idx="1"/>
          </p:cNvCxnSpPr>
          <p:nvPr/>
        </p:nvCxnSpPr>
        <p:spPr>
          <a:xfrm>
            <a:off x="2644920" y="1024560"/>
            <a:ext cx="2860920" cy="5133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51" name="テキスト ボックス 75"/>
          <p:cNvSpPr/>
          <p:nvPr/>
        </p:nvSpPr>
        <p:spPr>
          <a:xfrm>
            <a:off x="63360" y="60480"/>
            <a:ext cx="14860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Calibri"/>
                <a:ea typeface="Times New Roman"/>
              </a:rPr>
              <a:t>Fig.</a:t>
            </a:r>
            <a:r>
              <a:rPr b="1" lang="ja-JP" sz="2800" spc="-1" strike="noStrike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b="1" lang="en-US" sz="2800" spc="-1" strike="noStrike">
                <a:solidFill>
                  <a:srgbClr val="000000"/>
                </a:solidFill>
                <a:latin typeface="Calibri"/>
                <a:ea typeface="Times New Roman"/>
              </a:rPr>
              <a:t>S1A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テキスト ボックス 85"/>
          <p:cNvSpPr/>
          <p:nvPr/>
        </p:nvSpPr>
        <p:spPr>
          <a:xfrm>
            <a:off x="8267760" y="955800"/>
            <a:ext cx="66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t 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テキスト ボックス 86"/>
          <p:cNvSpPr/>
          <p:nvPr/>
        </p:nvSpPr>
        <p:spPr>
          <a:xfrm>
            <a:off x="8253360" y="1986120"/>
            <a:ext cx="603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t 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 Box 70"/>
          <p:cNvSpPr/>
          <p:nvPr/>
        </p:nvSpPr>
        <p:spPr>
          <a:xfrm>
            <a:off x="3862440" y="1589040"/>
            <a:ext cx="129060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M invas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直線コネクタ 110"/>
          <p:cNvSpPr/>
          <p:nvPr/>
        </p:nvSpPr>
        <p:spPr>
          <a:xfrm flipV="1">
            <a:off x="2644920" y="998280"/>
            <a:ext cx="0" cy="27000"/>
          </a:xfrm>
          <a:prstGeom prst="line">
            <a:avLst/>
          </a:prstGeom>
          <a:ln w="6480">
            <a:solidFill>
              <a:srgbClr val="5b9b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直線コネクタ 114"/>
          <p:cNvSpPr/>
          <p:nvPr/>
        </p:nvSpPr>
        <p:spPr>
          <a:xfrm flipH="1" flipV="1">
            <a:off x="2644920" y="1025280"/>
            <a:ext cx="1839600" cy="1554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 Box 70"/>
          <p:cNvSpPr/>
          <p:nvPr/>
        </p:nvSpPr>
        <p:spPr>
          <a:xfrm>
            <a:off x="3895560" y="1081080"/>
            <a:ext cx="1360800" cy="474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ts val="1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alateral developmen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58" name="直線矢印コネクタ 119"/>
          <p:cNvCxnSpPr>
            <a:stCxn id="91" idx="3"/>
          </p:cNvCxnSpPr>
          <p:nvPr/>
        </p:nvCxnSpPr>
        <p:spPr>
          <a:xfrm>
            <a:off x="2644920" y="1024560"/>
            <a:ext cx="1907280" cy="26370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9" name="直線矢印コネクタ 121"/>
          <p:cNvCxnSpPr>
            <a:stCxn id="91" idx="3"/>
          </p:cNvCxnSpPr>
          <p:nvPr/>
        </p:nvCxnSpPr>
        <p:spPr>
          <a:xfrm>
            <a:off x="2644920" y="1024560"/>
            <a:ext cx="1915200" cy="19782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60" name="Text Box 70"/>
          <p:cNvSpPr/>
          <p:nvPr/>
        </p:nvSpPr>
        <p:spPr>
          <a:xfrm>
            <a:off x="3017880" y="2135160"/>
            <a:ext cx="1477800" cy="665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ts val="1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croscopi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1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vasion</a:t>
            </a:r>
            <a:r>
              <a:rPr b="1" i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f the enucleated sit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星 5 81"/>
          <p:cNvSpPr/>
          <p:nvPr/>
        </p:nvSpPr>
        <p:spPr>
          <a:xfrm>
            <a:off x="8375760" y="858960"/>
            <a:ext cx="172800" cy="171360"/>
          </a:xfrm>
          <a:custGeom>
            <a:avLst/>
            <a:gdLst/>
            <a:ahLst/>
            <a:rect l="l" t="t" r="r" b="b"/>
            <a:pathLst>
              <a:path w="172528" h="171529">
                <a:moveTo>
                  <a:pt x="0" y="65518"/>
                </a:moveTo>
                <a:lnTo>
                  <a:pt x="65900" y="65519"/>
                </a:lnTo>
                <a:lnTo>
                  <a:pt x="86264" y="0"/>
                </a:lnTo>
                <a:lnTo>
                  <a:pt x="106628" y="65519"/>
                </a:lnTo>
                <a:lnTo>
                  <a:pt x="172528" y="65518"/>
                </a:lnTo>
                <a:lnTo>
                  <a:pt x="119213" y="106010"/>
                </a:lnTo>
                <a:lnTo>
                  <a:pt x="139578" y="171529"/>
                </a:lnTo>
                <a:lnTo>
                  <a:pt x="86264" y="131036"/>
                </a:lnTo>
                <a:lnTo>
                  <a:pt x="32950" y="171529"/>
                </a:lnTo>
                <a:lnTo>
                  <a:pt x="53315" y="106010"/>
                </a:lnTo>
                <a:lnTo>
                  <a:pt x="0" y="65518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41719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62" name="グループ化 1"/>
          <p:cNvGrpSpPr/>
          <p:nvPr/>
        </p:nvGrpSpPr>
        <p:grpSpPr>
          <a:xfrm>
            <a:off x="5892840" y="4781520"/>
            <a:ext cx="469800" cy="337320"/>
            <a:chOff x="5892840" y="4781520"/>
            <a:chExt cx="469800" cy="337320"/>
          </a:xfrm>
        </p:grpSpPr>
        <p:sp>
          <p:nvSpPr>
            <p:cNvPr id="163" name="楕円 88"/>
            <p:cNvSpPr/>
            <p:nvPr/>
          </p:nvSpPr>
          <p:spPr>
            <a:xfrm>
              <a:off x="5892840" y="4816440"/>
              <a:ext cx="469800" cy="277200"/>
            </a:xfrm>
            <a:prstGeom prst="ellipse">
              <a:avLst/>
            </a:prstGeom>
            <a:solidFill>
              <a:srgbClr val="ffffff"/>
            </a:solidFill>
            <a:ln w="28440">
              <a:solidFill>
                <a:srgbClr val="7f7f7f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テキスト ボックス 91"/>
            <p:cNvSpPr/>
            <p:nvPr/>
          </p:nvSpPr>
          <p:spPr>
            <a:xfrm>
              <a:off x="5895720" y="4781520"/>
              <a:ext cx="464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IAC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165" name="直線矢印コネクタ 104"/>
          <p:cNvCxnSpPr/>
          <p:nvPr/>
        </p:nvCxnSpPr>
        <p:spPr>
          <a:xfrm>
            <a:off x="6770160" y="1558440"/>
            <a:ext cx="4993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grpSp>
        <p:nvGrpSpPr>
          <p:cNvPr id="166" name="グループ化 92"/>
          <p:cNvGrpSpPr/>
          <p:nvPr/>
        </p:nvGrpSpPr>
        <p:grpSpPr>
          <a:xfrm>
            <a:off x="6613560" y="1380960"/>
            <a:ext cx="469800" cy="337320"/>
            <a:chOff x="6613560" y="1380960"/>
            <a:chExt cx="469800" cy="337320"/>
          </a:xfrm>
        </p:grpSpPr>
        <p:sp>
          <p:nvSpPr>
            <p:cNvPr id="167" name="楕円 96"/>
            <p:cNvSpPr/>
            <p:nvPr/>
          </p:nvSpPr>
          <p:spPr>
            <a:xfrm>
              <a:off x="6613560" y="1415880"/>
              <a:ext cx="469800" cy="275760"/>
            </a:xfrm>
            <a:prstGeom prst="ellipse">
              <a:avLst/>
            </a:prstGeom>
            <a:solidFill>
              <a:srgbClr val="ffffff"/>
            </a:solidFill>
            <a:ln w="28440">
              <a:solidFill>
                <a:srgbClr val="7f7f7f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テキスト ボックス 103"/>
            <p:cNvSpPr/>
            <p:nvPr/>
          </p:nvSpPr>
          <p:spPr>
            <a:xfrm>
              <a:off x="6616440" y="1380960"/>
              <a:ext cx="464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IAC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テキスト ボックス 21"/>
          <p:cNvSpPr/>
          <p:nvPr/>
        </p:nvSpPr>
        <p:spPr>
          <a:xfrm>
            <a:off x="82440" y="65160"/>
            <a:ext cx="13971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Calibri"/>
                <a:ea typeface="Times New Roman"/>
              </a:rPr>
              <a:t>Fig.</a:t>
            </a:r>
            <a:r>
              <a:rPr b="1" lang="ja-JP" sz="2800" spc="-1" strike="noStrike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b="1" lang="en-US" sz="2800" spc="-1" strike="noStrike">
                <a:solidFill>
                  <a:srgbClr val="000000"/>
                </a:solidFill>
                <a:latin typeface="Calibri"/>
                <a:ea typeface="Times New Roman"/>
              </a:rPr>
              <a:t>S1B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70" name="直線矢印コネクタ 164"/>
          <p:cNvCxnSpPr>
            <a:endCxn id="171" idx="1"/>
          </p:cNvCxnSpPr>
          <p:nvPr/>
        </p:nvCxnSpPr>
        <p:spPr>
          <a:xfrm>
            <a:off x="4271760" y="6222960"/>
            <a:ext cx="424440" cy="3484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72" name="直線矢印コネクタ 165"/>
          <p:cNvCxnSpPr/>
          <p:nvPr/>
        </p:nvCxnSpPr>
        <p:spPr>
          <a:xfrm>
            <a:off x="4982760" y="6116760"/>
            <a:ext cx="2451960" cy="86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73" name="直線矢印コネクタ 166"/>
          <p:cNvCxnSpPr/>
          <p:nvPr/>
        </p:nvCxnSpPr>
        <p:spPr>
          <a:xfrm>
            <a:off x="6461280" y="4613400"/>
            <a:ext cx="100080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74" name="直線矢印コネクタ 167"/>
          <p:cNvCxnSpPr/>
          <p:nvPr/>
        </p:nvCxnSpPr>
        <p:spPr>
          <a:xfrm flipV="1">
            <a:off x="6584760" y="3714120"/>
            <a:ext cx="88308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75" name="Text Box 70"/>
          <p:cNvSpPr/>
          <p:nvPr/>
        </p:nvSpPr>
        <p:spPr>
          <a:xfrm>
            <a:off x="2913120" y="201600"/>
            <a:ext cx="1368360" cy="58068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Local Tx of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the other sid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76" name="直線矢印コネクタ 171"/>
          <p:cNvCxnSpPr/>
          <p:nvPr/>
        </p:nvCxnSpPr>
        <p:spPr>
          <a:xfrm flipV="1">
            <a:off x="793440" y="648720"/>
            <a:ext cx="602280" cy="21675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77" name="直線矢印コネクタ 172"/>
          <p:cNvCxnSpPr/>
          <p:nvPr/>
        </p:nvCxnSpPr>
        <p:spPr>
          <a:xfrm>
            <a:off x="4272120" y="325080"/>
            <a:ext cx="312624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78" name="直線矢印コネクタ 173"/>
          <p:cNvCxnSpPr>
            <a:endCxn id="179" idx="1"/>
          </p:cNvCxnSpPr>
          <p:nvPr/>
        </p:nvCxnSpPr>
        <p:spPr>
          <a:xfrm>
            <a:off x="864720" y="3341160"/>
            <a:ext cx="957960" cy="10184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80" name="直線矢印コネクタ 174"/>
          <p:cNvCxnSpPr/>
          <p:nvPr/>
        </p:nvCxnSpPr>
        <p:spPr>
          <a:xfrm>
            <a:off x="3573000" y="4242960"/>
            <a:ext cx="382500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81" name="直線矢印コネクタ 175"/>
          <p:cNvCxnSpPr/>
          <p:nvPr/>
        </p:nvCxnSpPr>
        <p:spPr>
          <a:xfrm>
            <a:off x="4262400" y="495360"/>
            <a:ext cx="496080" cy="27151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82" name="直線矢印コネクタ 176"/>
          <p:cNvCxnSpPr>
            <a:endCxn id="183" idx="1"/>
          </p:cNvCxnSpPr>
          <p:nvPr/>
        </p:nvCxnSpPr>
        <p:spPr>
          <a:xfrm>
            <a:off x="3551400" y="4581000"/>
            <a:ext cx="505440" cy="4676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84" name="直線矢印コネクタ 177"/>
          <p:cNvCxnSpPr>
            <a:stCxn id="175" idx="3"/>
            <a:endCxn id="185" idx="1"/>
          </p:cNvCxnSpPr>
          <p:nvPr/>
        </p:nvCxnSpPr>
        <p:spPr>
          <a:xfrm>
            <a:off x="4281120" y="495000"/>
            <a:ext cx="994680" cy="9039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86" name="直線矢印コネクタ 178"/>
          <p:cNvCxnSpPr>
            <a:stCxn id="175" idx="3"/>
            <a:endCxn id="187" idx="1"/>
          </p:cNvCxnSpPr>
          <p:nvPr/>
        </p:nvCxnSpPr>
        <p:spPr>
          <a:xfrm>
            <a:off x="4281480" y="495000"/>
            <a:ext cx="792720" cy="308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88" name="テキスト ボックス 180"/>
          <p:cNvSpPr/>
          <p:nvPr/>
        </p:nvSpPr>
        <p:spPr>
          <a:xfrm>
            <a:off x="237600" y="324972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3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89" name="直線矢印コネクタ 182"/>
          <p:cNvCxnSpPr>
            <a:stCxn id="190" idx="3"/>
            <a:endCxn id="191" idx="1"/>
          </p:cNvCxnSpPr>
          <p:nvPr/>
        </p:nvCxnSpPr>
        <p:spPr>
          <a:xfrm flipV="1">
            <a:off x="5955840" y="5556960"/>
            <a:ext cx="159480" cy="2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92" name="テキスト ボックス 183"/>
          <p:cNvSpPr/>
          <p:nvPr/>
        </p:nvSpPr>
        <p:spPr>
          <a:xfrm>
            <a:off x="1347120" y="91764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2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テキスト ボックス 184"/>
          <p:cNvSpPr/>
          <p:nvPr/>
        </p:nvSpPr>
        <p:spPr>
          <a:xfrm>
            <a:off x="8154360" y="15876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テキスト ボックス 185"/>
          <p:cNvSpPr/>
          <p:nvPr/>
        </p:nvSpPr>
        <p:spPr>
          <a:xfrm>
            <a:off x="8169120" y="619200"/>
            <a:ext cx="36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9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テキスト ボックス 186"/>
          <p:cNvSpPr/>
          <p:nvPr/>
        </p:nvSpPr>
        <p:spPr>
          <a:xfrm>
            <a:off x="8263080" y="3459240"/>
            <a:ext cx="68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テキスト ボックス 187"/>
          <p:cNvSpPr/>
          <p:nvPr/>
        </p:nvSpPr>
        <p:spPr>
          <a:xfrm>
            <a:off x="1189080" y="420372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1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97" name="直線矢印コネクタ 188"/>
          <p:cNvCxnSpPr/>
          <p:nvPr/>
        </p:nvCxnSpPr>
        <p:spPr>
          <a:xfrm flipV="1">
            <a:off x="2698560" y="527760"/>
            <a:ext cx="1465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98" name="Text Box 70"/>
          <p:cNvSpPr/>
          <p:nvPr/>
        </p:nvSpPr>
        <p:spPr>
          <a:xfrm>
            <a:off x="5460840" y="3511440"/>
            <a:ext cx="1219320" cy="45900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Enucleat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Text Box 70"/>
          <p:cNvSpPr/>
          <p:nvPr/>
        </p:nvSpPr>
        <p:spPr>
          <a:xfrm>
            <a:off x="4991040" y="3483000"/>
            <a:ext cx="469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00" name="直線矢印コネクタ 192"/>
          <p:cNvCxnSpPr/>
          <p:nvPr/>
        </p:nvCxnSpPr>
        <p:spPr>
          <a:xfrm>
            <a:off x="4816080" y="3498840"/>
            <a:ext cx="237240" cy="164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79" name="Text Box 70"/>
          <p:cNvSpPr/>
          <p:nvPr/>
        </p:nvSpPr>
        <p:spPr>
          <a:xfrm>
            <a:off x="1822320" y="4067280"/>
            <a:ext cx="1721160" cy="580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Local Tx for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bil. preservat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テキスト ボックス 194"/>
          <p:cNvSpPr/>
          <p:nvPr/>
        </p:nvSpPr>
        <p:spPr>
          <a:xfrm>
            <a:off x="8190000" y="4030560"/>
            <a:ext cx="33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02" name="直線矢印コネクタ 196"/>
          <p:cNvCxnSpPr/>
          <p:nvPr/>
        </p:nvCxnSpPr>
        <p:spPr>
          <a:xfrm>
            <a:off x="4511160" y="4586040"/>
            <a:ext cx="747000" cy="39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03" name="直線矢印コネクタ 197"/>
          <p:cNvCxnSpPr>
            <a:endCxn id="204" idx="1"/>
          </p:cNvCxnSpPr>
          <p:nvPr/>
        </p:nvCxnSpPr>
        <p:spPr>
          <a:xfrm flipV="1">
            <a:off x="3551400" y="4585680"/>
            <a:ext cx="1018080" cy="39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05" name="テキスト ボックス 198"/>
          <p:cNvSpPr/>
          <p:nvPr/>
        </p:nvSpPr>
        <p:spPr>
          <a:xfrm>
            <a:off x="8185320" y="4486320"/>
            <a:ext cx="29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テキスト ボックス 199"/>
          <p:cNvSpPr/>
          <p:nvPr/>
        </p:nvSpPr>
        <p:spPr>
          <a:xfrm>
            <a:off x="8155080" y="5929200"/>
            <a:ext cx="77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07" name="直線矢印コネクタ 200"/>
          <p:cNvCxnSpPr>
            <a:stCxn id="183" idx="3"/>
          </p:cNvCxnSpPr>
          <p:nvPr/>
        </p:nvCxnSpPr>
        <p:spPr>
          <a:xfrm>
            <a:off x="4578120" y="5047920"/>
            <a:ext cx="2819880" cy="54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04" name="Text Box 70"/>
          <p:cNvSpPr/>
          <p:nvPr/>
        </p:nvSpPr>
        <p:spPr>
          <a:xfrm>
            <a:off x="4568760" y="4357440"/>
            <a:ext cx="468360" cy="45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Text Box 70"/>
          <p:cNvSpPr/>
          <p:nvPr/>
        </p:nvSpPr>
        <p:spPr>
          <a:xfrm>
            <a:off x="4056120" y="4856040"/>
            <a:ext cx="522360" cy="459000"/>
          </a:xfrm>
          <a:prstGeom prst="rect">
            <a:avLst/>
          </a:prstGeom>
          <a:solidFill>
            <a:srgbClr val="d9d9d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R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Text Box 70"/>
          <p:cNvSpPr/>
          <p:nvPr/>
        </p:nvSpPr>
        <p:spPr>
          <a:xfrm>
            <a:off x="5487840" y="5329080"/>
            <a:ext cx="468360" cy="45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テキスト ボックス 204"/>
          <p:cNvSpPr/>
          <p:nvPr/>
        </p:nvSpPr>
        <p:spPr>
          <a:xfrm>
            <a:off x="8186760" y="4943520"/>
            <a:ext cx="32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09" name="直線矢印コネクタ 206"/>
          <p:cNvCxnSpPr/>
          <p:nvPr/>
        </p:nvCxnSpPr>
        <p:spPr>
          <a:xfrm flipV="1">
            <a:off x="5149800" y="6625440"/>
            <a:ext cx="146880" cy="2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71" name="Text Box 70"/>
          <p:cNvSpPr/>
          <p:nvPr/>
        </p:nvSpPr>
        <p:spPr>
          <a:xfrm>
            <a:off x="4695840" y="6341040"/>
            <a:ext cx="469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10" name="直線矢印コネクタ 208"/>
          <p:cNvCxnSpPr/>
          <p:nvPr/>
        </p:nvCxnSpPr>
        <p:spPr>
          <a:xfrm flipV="1">
            <a:off x="6477120" y="6570360"/>
            <a:ext cx="94680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11" name="テキスト ボックス 209"/>
          <p:cNvSpPr/>
          <p:nvPr/>
        </p:nvSpPr>
        <p:spPr>
          <a:xfrm>
            <a:off x="8172360" y="6377040"/>
            <a:ext cx="32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Text Box 70"/>
          <p:cNvSpPr/>
          <p:nvPr/>
        </p:nvSpPr>
        <p:spPr>
          <a:xfrm>
            <a:off x="5270400" y="6341760"/>
            <a:ext cx="1179720" cy="45900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Enucleat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テキスト ボックス 211"/>
          <p:cNvSpPr/>
          <p:nvPr/>
        </p:nvSpPr>
        <p:spPr>
          <a:xfrm>
            <a:off x="7461360" y="152280"/>
            <a:ext cx="682560" cy="36828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テキスト ボックス 215"/>
          <p:cNvSpPr/>
          <p:nvPr/>
        </p:nvSpPr>
        <p:spPr>
          <a:xfrm>
            <a:off x="7461360" y="4025880"/>
            <a:ext cx="68256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テキスト ボックス 216"/>
          <p:cNvSpPr/>
          <p:nvPr/>
        </p:nvSpPr>
        <p:spPr>
          <a:xfrm>
            <a:off x="7461360" y="4465800"/>
            <a:ext cx="682560" cy="368280"/>
          </a:xfrm>
          <a:prstGeom prst="rect">
            <a:avLst/>
          </a:prstGeom>
          <a:solidFill>
            <a:srgbClr val="ffff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テキスト ボックス 218"/>
          <p:cNvSpPr/>
          <p:nvPr/>
        </p:nvSpPr>
        <p:spPr>
          <a:xfrm>
            <a:off x="7461360" y="5921280"/>
            <a:ext cx="682560" cy="368280"/>
          </a:xfrm>
          <a:prstGeom prst="rect">
            <a:avLst/>
          </a:prstGeom>
          <a:solidFill>
            <a:srgbClr val="d9d9d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17" name="直線矢印コネクタ 220"/>
          <p:cNvCxnSpPr/>
          <p:nvPr/>
        </p:nvCxnSpPr>
        <p:spPr>
          <a:xfrm flipV="1">
            <a:off x="5497200" y="1315440"/>
            <a:ext cx="1888200" cy="54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18" name="直線矢印コネクタ 221"/>
          <p:cNvCxnSpPr>
            <a:stCxn id="185" idx="3"/>
            <a:endCxn id="219" idx="1"/>
          </p:cNvCxnSpPr>
          <p:nvPr/>
        </p:nvCxnSpPr>
        <p:spPr>
          <a:xfrm>
            <a:off x="5797080" y="1398240"/>
            <a:ext cx="1667880" cy="3452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20" name="テキスト ボックス 222"/>
          <p:cNvSpPr/>
          <p:nvPr/>
        </p:nvSpPr>
        <p:spPr>
          <a:xfrm>
            <a:off x="8255880" y="153828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テキスト ボックス 223"/>
          <p:cNvSpPr/>
          <p:nvPr/>
        </p:nvSpPr>
        <p:spPr>
          <a:xfrm>
            <a:off x="8186760" y="1082520"/>
            <a:ext cx="366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テキスト ボックス 225"/>
          <p:cNvSpPr/>
          <p:nvPr/>
        </p:nvSpPr>
        <p:spPr>
          <a:xfrm>
            <a:off x="7461360" y="1096920"/>
            <a:ext cx="682560" cy="36828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23" name="直線矢印コネクタ 228"/>
          <p:cNvCxnSpPr/>
          <p:nvPr/>
        </p:nvCxnSpPr>
        <p:spPr>
          <a:xfrm flipV="1">
            <a:off x="6114960" y="3150720"/>
            <a:ext cx="1347120" cy="72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24" name="直線矢印コネクタ 229"/>
          <p:cNvCxnSpPr/>
          <p:nvPr/>
        </p:nvCxnSpPr>
        <p:spPr>
          <a:xfrm>
            <a:off x="6928920" y="2704680"/>
            <a:ext cx="505800" cy="2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25" name="テキスト ボックス 230"/>
          <p:cNvSpPr/>
          <p:nvPr/>
        </p:nvSpPr>
        <p:spPr>
          <a:xfrm>
            <a:off x="8169120" y="2982960"/>
            <a:ext cx="333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26" name="直線矢印コネクタ 233"/>
          <p:cNvCxnSpPr>
            <a:stCxn id="185" idx="3"/>
            <a:endCxn id="227" idx="1"/>
          </p:cNvCxnSpPr>
          <p:nvPr/>
        </p:nvCxnSpPr>
        <p:spPr>
          <a:xfrm>
            <a:off x="5797440" y="1398600"/>
            <a:ext cx="1664640" cy="8071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28" name="Text Box 70"/>
          <p:cNvSpPr/>
          <p:nvPr/>
        </p:nvSpPr>
        <p:spPr>
          <a:xfrm>
            <a:off x="5041800" y="2406600"/>
            <a:ext cx="468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29" name="直線矢印コネクタ 238"/>
          <p:cNvCxnSpPr>
            <a:stCxn id="175" idx="3"/>
            <a:endCxn id="228" idx="1"/>
          </p:cNvCxnSpPr>
          <p:nvPr/>
        </p:nvCxnSpPr>
        <p:spPr>
          <a:xfrm>
            <a:off x="4281480" y="495360"/>
            <a:ext cx="761040" cy="21405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30" name="直線矢印コネクタ 239"/>
          <p:cNvCxnSpPr/>
          <p:nvPr/>
        </p:nvCxnSpPr>
        <p:spPr>
          <a:xfrm>
            <a:off x="5406840" y="2668680"/>
            <a:ext cx="25596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91" name="Text Box 70"/>
          <p:cNvSpPr/>
          <p:nvPr/>
        </p:nvSpPr>
        <p:spPr>
          <a:xfrm>
            <a:off x="6114960" y="5327640"/>
            <a:ext cx="1190880" cy="45900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Enucleat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31" name="直線矢印コネクタ 247"/>
          <p:cNvCxnSpPr/>
          <p:nvPr/>
        </p:nvCxnSpPr>
        <p:spPr>
          <a:xfrm>
            <a:off x="3573360" y="4581000"/>
            <a:ext cx="448560" cy="9421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32" name="直線矢印コネクタ 248"/>
          <p:cNvCxnSpPr/>
          <p:nvPr/>
        </p:nvCxnSpPr>
        <p:spPr>
          <a:xfrm>
            <a:off x="3548160" y="4568760"/>
            <a:ext cx="505440" cy="14565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33" name="直線矢印コネクタ 249"/>
          <p:cNvCxnSpPr/>
          <p:nvPr/>
        </p:nvCxnSpPr>
        <p:spPr>
          <a:xfrm>
            <a:off x="6114600" y="752040"/>
            <a:ext cx="124524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34" name="直線矢印コネクタ 250"/>
          <p:cNvCxnSpPr/>
          <p:nvPr/>
        </p:nvCxnSpPr>
        <p:spPr>
          <a:xfrm flipV="1">
            <a:off x="7294680" y="5543280"/>
            <a:ext cx="13356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35" name="直線矢印コネクタ 251"/>
          <p:cNvCxnSpPr/>
          <p:nvPr/>
        </p:nvCxnSpPr>
        <p:spPr>
          <a:xfrm flipV="1">
            <a:off x="5362200" y="5543280"/>
            <a:ext cx="135720" cy="21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36" name="Text Box 70"/>
          <p:cNvSpPr/>
          <p:nvPr/>
        </p:nvSpPr>
        <p:spPr>
          <a:xfrm>
            <a:off x="68400" y="2835360"/>
            <a:ext cx="175392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Bilateral-onse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Text Box 70"/>
          <p:cNvSpPr/>
          <p:nvPr/>
        </p:nvSpPr>
        <p:spPr>
          <a:xfrm>
            <a:off x="1495440" y="291960"/>
            <a:ext cx="1184400" cy="45900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Enucleat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Text Box 70"/>
          <p:cNvSpPr/>
          <p:nvPr/>
        </p:nvSpPr>
        <p:spPr>
          <a:xfrm>
            <a:off x="5073480" y="574560"/>
            <a:ext cx="1046160" cy="45900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Chemo Tx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テキスト ボックス 91"/>
          <p:cNvSpPr/>
          <p:nvPr/>
        </p:nvSpPr>
        <p:spPr>
          <a:xfrm>
            <a:off x="7456320" y="603360"/>
            <a:ext cx="682920" cy="36828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Text Box 70"/>
          <p:cNvSpPr/>
          <p:nvPr/>
        </p:nvSpPr>
        <p:spPr>
          <a:xfrm>
            <a:off x="5275440" y="1168920"/>
            <a:ext cx="522000" cy="45900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R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テキスト ボックス 95"/>
          <p:cNvSpPr/>
          <p:nvPr/>
        </p:nvSpPr>
        <p:spPr>
          <a:xfrm>
            <a:off x="7464600" y="1557360"/>
            <a:ext cx="803160" cy="368280"/>
          </a:xfrm>
          <a:prstGeom prst="rect">
            <a:avLst/>
          </a:prstGeom>
          <a:solidFill>
            <a:srgbClr val="000000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Calibri"/>
                <a:ea typeface="Times New Roman"/>
              </a:rPr>
              <a:t>Dea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Text Box 70"/>
          <p:cNvSpPr/>
          <p:nvPr/>
        </p:nvSpPr>
        <p:spPr>
          <a:xfrm>
            <a:off x="5702400" y="2266920"/>
            <a:ext cx="1325520" cy="82404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RT+Chemo Tx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Text Box 70"/>
          <p:cNvSpPr/>
          <p:nvPr/>
        </p:nvSpPr>
        <p:spPr>
          <a:xfrm>
            <a:off x="4776840" y="2797200"/>
            <a:ext cx="1325520" cy="82404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RT+Chemo Tx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テキスト ボックス 101"/>
          <p:cNvSpPr/>
          <p:nvPr/>
        </p:nvSpPr>
        <p:spPr>
          <a:xfrm>
            <a:off x="7512120" y="2976480"/>
            <a:ext cx="682560" cy="36828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テキスト ボックス 102"/>
          <p:cNvSpPr/>
          <p:nvPr/>
        </p:nvSpPr>
        <p:spPr>
          <a:xfrm>
            <a:off x="7537320" y="3479760"/>
            <a:ext cx="649440" cy="368280"/>
          </a:xfrm>
          <a:prstGeom prst="rect">
            <a:avLst/>
          </a:prstGeom>
          <a:solidFill>
            <a:srgbClr val="d9d9d9"/>
          </a:solidFill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Text Box 70"/>
          <p:cNvSpPr/>
          <p:nvPr/>
        </p:nvSpPr>
        <p:spPr>
          <a:xfrm>
            <a:off x="5334120" y="4449600"/>
            <a:ext cx="1212840" cy="459000"/>
          </a:xfrm>
          <a:prstGeom prst="rect">
            <a:avLst/>
          </a:prstGeom>
          <a:solidFill>
            <a:srgbClr val="ffff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Enucleat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テキスト ボックス 106"/>
          <p:cNvSpPr/>
          <p:nvPr/>
        </p:nvSpPr>
        <p:spPr>
          <a:xfrm>
            <a:off x="7469280" y="4906800"/>
            <a:ext cx="682560" cy="368280"/>
          </a:xfrm>
          <a:prstGeom prst="rect">
            <a:avLst/>
          </a:prstGeom>
          <a:solidFill>
            <a:srgbClr val="d9d9d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Text Box 70"/>
          <p:cNvSpPr/>
          <p:nvPr/>
        </p:nvSpPr>
        <p:spPr>
          <a:xfrm>
            <a:off x="4046400" y="5337000"/>
            <a:ext cx="1332000" cy="459000"/>
          </a:xfrm>
          <a:prstGeom prst="rect">
            <a:avLst/>
          </a:prstGeom>
          <a:solidFill>
            <a:srgbClr val="d9d9d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RT+Chemo Tx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Text Box 70"/>
          <p:cNvSpPr/>
          <p:nvPr/>
        </p:nvSpPr>
        <p:spPr>
          <a:xfrm>
            <a:off x="4078440" y="5843520"/>
            <a:ext cx="1046160" cy="459000"/>
          </a:xfrm>
          <a:prstGeom prst="rect">
            <a:avLst/>
          </a:prstGeom>
          <a:solidFill>
            <a:srgbClr val="d9d9d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Chemo Tx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テキスト ボックス 110"/>
          <p:cNvSpPr/>
          <p:nvPr/>
        </p:nvSpPr>
        <p:spPr>
          <a:xfrm>
            <a:off x="7472520" y="6377040"/>
            <a:ext cx="684000" cy="368280"/>
          </a:xfrm>
          <a:prstGeom prst="rect">
            <a:avLst/>
          </a:prstGeom>
          <a:solidFill>
            <a:srgbClr val="d9d9d9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テキスト ボックス 97"/>
          <p:cNvSpPr/>
          <p:nvPr/>
        </p:nvSpPr>
        <p:spPr>
          <a:xfrm>
            <a:off x="8442360" y="1568520"/>
            <a:ext cx="64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t 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テキスト ボックス 112"/>
          <p:cNvSpPr/>
          <p:nvPr/>
        </p:nvSpPr>
        <p:spPr>
          <a:xfrm>
            <a:off x="8261280" y="201924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テキスト ボックス 113"/>
          <p:cNvSpPr/>
          <p:nvPr/>
        </p:nvSpPr>
        <p:spPr>
          <a:xfrm>
            <a:off x="8448840" y="2049480"/>
            <a:ext cx="64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t 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テキスト ボックス 114"/>
          <p:cNvSpPr/>
          <p:nvPr/>
        </p:nvSpPr>
        <p:spPr>
          <a:xfrm>
            <a:off x="8259120" y="249084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テキスト ボックス 116"/>
          <p:cNvSpPr/>
          <p:nvPr/>
        </p:nvSpPr>
        <p:spPr>
          <a:xfrm>
            <a:off x="8445600" y="2521080"/>
            <a:ext cx="64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t 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テキスト ボックス 117"/>
          <p:cNvSpPr/>
          <p:nvPr/>
        </p:nvSpPr>
        <p:spPr>
          <a:xfrm>
            <a:off x="8267040" y="536256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テキスト ボックス 118"/>
          <p:cNvSpPr/>
          <p:nvPr/>
        </p:nvSpPr>
        <p:spPr>
          <a:xfrm>
            <a:off x="8453520" y="5392800"/>
            <a:ext cx="64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t 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テキスト ボックス 119"/>
          <p:cNvSpPr/>
          <p:nvPr/>
        </p:nvSpPr>
        <p:spPr>
          <a:xfrm>
            <a:off x="8453520" y="2997360"/>
            <a:ext cx="64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t 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フレーム 1"/>
          <p:cNvSpPr/>
          <p:nvPr/>
        </p:nvSpPr>
        <p:spPr>
          <a:xfrm>
            <a:off x="7480440" y="3427560"/>
            <a:ext cx="777600" cy="485640"/>
          </a:xfrm>
          <a:custGeom>
            <a:avLst/>
            <a:gdLst/>
            <a:ahLst/>
            <a:rect l="l" t="t" r="r" b="b"/>
            <a:pathLst>
              <a:path w="777678" h="486476">
                <a:moveTo>
                  <a:pt x="0" y="0"/>
                </a:moveTo>
                <a:lnTo>
                  <a:pt x="777678" y="0"/>
                </a:lnTo>
                <a:lnTo>
                  <a:pt x="777678" y="486476"/>
                </a:lnTo>
                <a:lnTo>
                  <a:pt x="0" y="486476"/>
                </a:lnTo>
                <a:lnTo>
                  <a:pt x="0" y="0"/>
                </a:lnTo>
                <a:close/>
                <a:moveTo>
                  <a:pt x="60810" y="60810"/>
                </a:moveTo>
                <a:lnTo>
                  <a:pt x="60810" y="425667"/>
                </a:lnTo>
                <a:lnTo>
                  <a:pt x="716869" y="425667"/>
                </a:lnTo>
                <a:lnTo>
                  <a:pt x="716869" y="60810"/>
                </a:lnTo>
                <a:lnTo>
                  <a:pt x="60810" y="60810"/>
                </a:lnTo>
                <a:close/>
              </a:path>
            </a:pathLst>
          </a:cu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星 5 2"/>
          <p:cNvSpPr/>
          <p:nvPr/>
        </p:nvSpPr>
        <p:spPr>
          <a:xfrm>
            <a:off x="6173640" y="1712880"/>
            <a:ext cx="171720" cy="171360"/>
          </a:xfrm>
          <a:custGeom>
            <a:avLst/>
            <a:gdLst/>
            <a:ahLst/>
            <a:rect l="l" t="t" r="r" b="b"/>
            <a:pathLst>
              <a:path w="172528" h="171529">
                <a:moveTo>
                  <a:pt x="0" y="65518"/>
                </a:moveTo>
                <a:lnTo>
                  <a:pt x="65900" y="65519"/>
                </a:lnTo>
                <a:lnTo>
                  <a:pt x="86264" y="0"/>
                </a:lnTo>
                <a:lnTo>
                  <a:pt x="106628" y="65519"/>
                </a:lnTo>
                <a:lnTo>
                  <a:pt x="172528" y="65518"/>
                </a:lnTo>
                <a:lnTo>
                  <a:pt x="119213" y="106010"/>
                </a:lnTo>
                <a:lnTo>
                  <a:pt x="139578" y="171529"/>
                </a:lnTo>
                <a:lnTo>
                  <a:pt x="86264" y="131036"/>
                </a:lnTo>
                <a:lnTo>
                  <a:pt x="32950" y="171529"/>
                </a:lnTo>
                <a:lnTo>
                  <a:pt x="53315" y="106010"/>
                </a:lnTo>
                <a:lnTo>
                  <a:pt x="0" y="65518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41719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星 5 96"/>
          <p:cNvSpPr/>
          <p:nvPr/>
        </p:nvSpPr>
        <p:spPr>
          <a:xfrm>
            <a:off x="8393040" y="3006720"/>
            <a:ext cx="173160" cy="171360"/>
          </a:xfrm>
          <a:custGeom>
            <a:avLst/>
            <a:gdLst/>
            <a:ahLst/>
            <a:rect l="l" t="t" r="r" b="b"/>
            <a:pathLst>
              <a:path w="172528" h="171529">
                <a:moveTo>
                  <a:pt x="0" y="65518"/>
                </a:moveTo>
                <a:lnTo>
                  <a:pt x="65900" y="65519"/>
                </a:lnTo>
                <a:lnTo>
                  <a:pt x="86264" y="0"/>
                </a:lnTo>
                <a:lnTo>
                  <a:pt x="106628" y="65519"/>
                </a:lnTo>
                <a:lnTo>
                  <a:pt x="172528" y="65518"/>
                </a:lnTo>
                <a:lnTo>
                  <a:pt x="119213" y="106010"/>
                </a:lnTo>
                <a:lnTo>
                  <a:pt x="139578" y="171529"/>
                </a:lnTo>
                <a:lnTo>
                  <a:pt x="86264" y="131036"/>
                </a:lnTo>
                <a:lnTo>
                  <a:pt x="32950" y="171529"/>
                </a:lnTo>
                <a:lnTo>
                  <a:pt x="53315" y="106010"/>
                </a:lnTo>
                <a:lnTo>
                  <a:pt x="0" y="65518"/>
                </a:lnTo>
                <a:close/>
              </a:path>
            </a:pathLst>
          </a:custGeom>
          <a:solidFill>
            <a:srgbClr val="000000"/>
          </a:solidFill>
          <a:ln w="12600">
            <a:solidFill>
              <a:srgbClr val="41719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テキスト ボックス 100"/>
          <p:cNvSpPr/>
          <p:nvPr/>
        </p:nvSpPr>
        <p:spPr>
          <a:xfrm>
            <a:off x="7461360" y="2021040"/>
            <a:ext cx="803160" cy="368280"/>
          </a:xfrm>
          <a:prstGeom prst="rect">
            <a:avLst/>
          </a:prstGeom>
          <a:solidFill>
            <a:srgbClr val="000000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Calibri"/>
                <a:ea typeface="Times New Roman"/>
              </a:rPr>
              <a:t>Dea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テキスト ボックス 104"/>
          <p:cNvSpPr/>
          <p:nvPr/>
        </p:nvSpPr>
        <p:spPr>
          <a:xfrm>
            <a:off x="7458120" y="2500200"/>
            <a:ext cx="803160" cy="368280"/>
          </a:xfrm>
          <a:prstGeom prst="rect">
            <a:avLst/>
          </a:prstGeom>
          <a:solidFill>
            <a:srgbClr val="000000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Calibri"/>
                <a:ea typeface="Times New Roman"/>
              </a:rPr>
              <a:t>Dea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テキスト ボックス 105"/>
          <p:cNvSpPr/>
          <p:nvPr/>
        </p:nvSpPr>
        <p:spPr>
          <a:xfrm>
            <a:off x="7464600" y="5380200"/>
            <a:ext cx="803160" cy="368280"/>
          </a:xfrm>
          <a:prstGeom prst="rect">
            <a:avLst/>
          </a:prstGeom>
          <a:solidFill>
            <a:srgbClr val="000000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Calibri"/>
                <a:ea typeface="Times New Roman"/>
              </a:rPr>
              <a:t>Dea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61" name="グループ化 126"/>
          <p:cNvGrpSpPr/>
          <p:nvPr/>
        </p:nvGrpSpPr>
        <p:grpSpPr>
          <a:xfrm>
            <a:off x="6708600" y="3556080"/>
            <a:ext cx="470160" cy="337320"/>
            <a:chOff x="6708600" y="3556080"/>
            <a:chExt cx="470160" cy="337320"/>
          </a:xfrm>
        </p:grpSpPr>
        <p:sp>
          <p:nvSpPr>
            <p:cNvPr id="262" name="楕円 127"/>
            <p:cNvSpPr/>
            <p:nvPr/>
          </p:nvSpPr>
          <p:spPr>
            <a:xfrm>
              <a:off x="6708600" y="3591000"/>
              <a:ext cx="470160" cy="275760"/>
            </a:xfrm>
            <a:prstGeom prst="ellipse">
              <a:avLst/>
            </a:prstGeom>
            <a:solidFill>
              <a:srgbClr val="ffffff"/>
            </a:solidFill>
            <a:ln w="28440">
              <a:solidFill>
                <a:srgbClr val="7f7f7f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テキスト ボックス 128"/>
            <p:cNvSpPr/>
            <p:nvPr/>
          </p:nvSpPr>
          <p:spPr>
            <a:xfrm>
              <a:off x="6711480" y="3556080"/>
              <a:ext cx="464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IAC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64" name="グループ化 129"/>
          <p:cNvGrpSpPr/>
          <p:nvPr/>
        </p:nvGrpSpPr>
        <p:grpSpPr>
          <a:xfrm>
            <a:off x="6638760" y="5961240"/>
            <a:ext cx="470160" cy="337320"/>
            <a:chOff x="6638760" y="5961240"/>
            <a:chExt cx="470160" cy="337320"/>
          </a:xfrm>
        </p:grpSpPr>
        <p:sp>
          <p:nvSpPr>
            <p:cNvPr id="265" name="楕円 130"/>
            <p:cNvSpPr/>
            <p:nvPr/>
          </p:nvSpPr>
          <p:spPr>
            <a:xfrm>
              <a:off x="6638760" y="5996160"/>
              <a:ext cx="470160" cy="276840"/>
            </a:xfrm>
            <a:prstGeom prst="ellipse">
              <a:avLst/>
            </a:prstGeom>
            <a:solidFill>
              <a:srgbClr val="ffffff"/>
            </a:solidFill>
            <a:ln w="28440">
              <a:solidFill>
                <a:srgbClr val="7f7f7f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テキスト ボックス 131"/>
            <p:cNvSpPr/>
            <p:nvPr/>
          </p:nvSpPr>
          <p:spPr>
            <a:xfrm>
              <a:off x="6641640" y="5961240"/>
              <a:ext cx="464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IAC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67" name="グループ化 132"/>
          <p:cNvGrpSpPr/>
          <p:nvPr/>
        </p:nvGrpSpPr>
        <p:grpSpPr>
          <a:xfrm>
            <a:off x="6659640" y="6394320"/>
            <a:ext cx="471240" cy="337320"/>
            <a:chOff x="6659640" y="6394320"/>
            <a:chExt cx="471240" cy="337320"/>
          </a:xfrm>
        </p:grpSpPr>
        <p:sp>
          <p:nvSpPr>
            <p:cNvPr id="268" name="楕円 133"/>
            <p:cNvSpPr/>
            <p:nvPr/>
          </p:nvSpPr>
          <p:spPr>
            <a:xfrm>
              <a:off x="6659640" y="6429240"/>
              <a:ext cx="471240" cy="275760"/>
            </a:xfrm>
            <a:prstGeom prst="ellipse">
              <a:avLst/>
            </a:prstGeom>
            <a:solidFill>
              <a:srgbClr val="ffffff"/>
            </a:solidFill>
            <a:ln w="28440">
              <a:solidFill>
                <a:srgbClr val="7f7f7f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テキスト ボックス 134"/>
            <p:cNvSpPr/>
            <p:nvPr/>
          </p:nvSpPr>
          <p:spPr>
            <a:xfrm>
              <a:off x="6663240" y="6394320"/>
              <a:ext cx="464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IAC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70" name="テキスト ボックス 108"/>
          <p:cNvSpPr/>
          <p:nvPr/>
        </p:nvSpPr>
        <p:spPr>
          <a:xfrm>
            <a:off x="7087320" y="639288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テキスト ボックス 111"/>
          <p:cNvSpPr/>
          <p:nvPr/>
        </p:nvSpPr>
        <p:spPr>
          <a:xfrm>
            <a:off x="7077960" y="593100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テキスト ボックス 115"/>
          <p:cNvSpPr/>
          <p:nvPr/>
        </p:nvSpPr>
        <p:spPr>
          <a:xfrm>
            <a:off x="7112880" y="352440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3" name="テキスト ボックス 130"/>
          <p:cNvSpPr/>
          <p:nvPr/>
        </p:nvSpPr>
        <p:spPr>
          <a:xfrm>
            <a:off x="1282680" y="5543640"/>
            <a:ext cx="1106640" cy="34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ts val="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vitreous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ts val="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disseminatio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テキスト ボックス 238"/>
          <p:cNvSpPr/>
          <p:nvPr/>
        </p:nvSpPr>
        <p:spPr>
          <a:xfrm>
            <a:off x="1587600" y="2708280"/>
            <a:ext cx="828720" cy="154080"/>
          </a:xfrm>
          <a:prstGeom prst="rect">
            <a:avLst/>
          </a:prstGeom>
          <a:solidFill>
            <a:srgbClr val="afabab"/>
          </a:solidFill>
          <a:ln w="9360">
            <a:solidFill>
              <a:srgbClr val="afaba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テキスト ボックス 275"/>
          <p:cNvSpPr/>
          <p:nvPr/>
        </p:nvSpPr>
        <p:spPr>
          <a:xfrm>
            <a:off x="3571920" y="4367160"/>
            <a:ext cx="896760" cy="34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ts val="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CNS metastasi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テキスト ボックス 266"/>
          <p:cNvSpPr/>
          <p:nvPr/>
        </p:nvSpPr>
        <p:spPr>
          <a:xfrm>
            <a:off x="1360440" y="5021280"/>
            <a:ext cx="6478560" cy="183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テキスト ボックス 216"/>
          <p:cNvSpPr/>
          <p:nvPr/>
        </p:nvSpPr>
        <p:spPr>
          <a:xfrm>
            <a:off x="1351080" y="3049560"/>
            <a:ext cx="4680000" cy="184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テキスト ボックス 235"/>
          <p:cNvSpPr/>
          <p:nvPr/>
        </p:nvSpPr>
        <p:spPr>
          <a:xfrm>
            <a:off x="2475000" y="3070080"/>
            <a:ext cx="3355920" cy="154080"/>
          </a:xfrm>
          <a:prstGeom prst="rect">
            <a:avLst/>
          </a:prstGeom>
          <a:solidFill>
            <a:srgbClr val="d6dce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テキスト ボックス 114"/>
          <p:cNvSpPr/>
          <p:nvPr/>
        </p:nvSpPr>
        <p:spPr>
          <a:xfrm>
            <a:off x="1360440" y="1049400"/>
            <a:ext cx="3598920" cy="183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テキスト ボックス 80"/>
          <p:cNvSpPr/>
          <p:nvPr/>
        </p:nvSpPr>
        <p:spPr>
          <a:xfrm>
            <a:off x="1154160" y="1343160"/>
            <a:ext cx="480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テキスト ボックス 91"/>
          <p:cNvSpPr/>
          <p:nvPr/>
        </p:nvSpPr>
        <p:spPr>
          <a:xfrm>
            <a:off x="4533840" y="1357200"/>
            <a:ext cx="59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15</a:t>
            </a:r>
            <a:r>
              <a:rPr b="0" lang="ja-JP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テキスト ボックス 110"/>
          <p:cNvSpPr/>
          <p:nvPr/>
        </p:nvSpPr>
        <p:spPr>
          <a:xfrm>
            <a:off x="115920" y="923760"/>
            <a:ext cx="89532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Pt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bil.</a:t>
            </a:r>
            <a:r>
              <a:rPr b="1" lang="ja-JP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→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tri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テキスト ボックス 115"/>
          <p:cNvSpPr/>
          <p:nvPr/>
        </p:nvSpPr>
        <p:spPr>
          <a:xfrm>
            <a:off x="1355760" y="1238400"/>
            <a:ext cx="220680" cy="183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テキスト ボックス 1"/>
          <p:cNvSpPr/>
          <p:nvPr/>
        </p:nvSpPr>
        <p:spPr>
          <a:xfrm>
            <a:off x="1062000" y="1003320"/>
            <a:ext cx="469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Rt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テキスト ボックス 129"/>
          <p:cNvSpPr/>
          <p:nvPr/>
        </p:nvSpPr>
        <p:spPr>
          <a:xfrm>
            <a:off x="1079640" y="1155600"/>
            <a:ext cx="471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Lt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テキスト ボックス 147"/>
          <p:cNvSpPr/>
          <p:nvPr/>
        </p:nvSpPr>
        <p:spPr>
          <a:xfrm>
            <a:off x="2257560" y="760320"/>
            <a:ext cx="771480" cy="22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ts val="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CSF(+) tri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下矢印 148"/>
          <p:cNvSpPr/>
          <p:nvPr/>
        </p:nvSpPr>
        <p:spPr>
          <a:xfrm>
            <a:off x="2682720" y="965160"/>
            <a:ext cx="104760" cy="7164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000000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テキスト ボックス 152"/>
          <p:cNvSpPr/>
          <p:nvPr/>
        </p:nvSpPr>
        <p:spPr>
          <a:xfrm>
            <a:off x="2523960" y="1338120"/>
            <a:ext cx="47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テキスト ボックス 100"/>
          <p:cNvSpPr/>
          <p:nvPr/>
        </p:nvSpPr>
        <p:spPr>
          <a:xfrm>
            <a:off x="1590840" y="1071720"/>
            <a:ext cx="828360" cy="153720"/>
          </a:xfrm>
          <a:prstGeom prst="rect">
            <a:avLst/>
          </a:prstGeom>
          <a:solidFill>
            <a:srgbClr val="d6dce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テキスト ボックス 13"/>
          <p:cNvSpPr/>
          <p:nvPr/>
        </p:nvSpPr>
        <p:spPr>
          <a:xfrm>
            <a:off x="1662120" y="998640"/>
            <a:ext cx="66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Loca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テキスト ボックス 153"/>
          <p:cNvSpPr/>
          <p:nvPr/>
        </p:nvSpPr>
        <p:spPr>
          <a:xfrm>
            <a:off x="2967120" y="728640"/>
            <a:ext cx="828720" cy="154080"/>
          </a:xfrm>
          <a:prstGeom prst="rect">
            <a:avLst/>
          </a:prstGeom>
          <a:solidFill>
            <a:srgbClr val="afabab"/>
          </a:solidFill>
          <a:ln w="9360">
            <a:solidFill>
              <a:srgbClr val="afaba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テキスト ボックス 160"/>
          <p:cNvSpPr/>
          <p:nvPr/>
        </p:nvSpPr>
        <p:spPr>
          <a:xfrm>
            <a:off x="3111480" y="890640"/>
            <a:ext cx="1800360" cy="154080"/>
          </a:xfrm>
          <a:prstGeom prst="rect">
            <a:avLst/>
          </a:prstGeom>
          <a:solidFill>
            <a:srgbClr val="595959"/>
          </a:solidFill>
          <a:ln w="9360">
            <a:solidFill>
              <a:srgbClr val="5959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テキスト ボックス 162"/>
          <p:cNvSpPr/>
          <p:nvPr/>
        </p:nvSpPr>
        <p:spPr>
          <a:xfrm>
            <a:off x="3632040" y="819000"/>
            <a:ext cx="871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Chemo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テキスト ボックス 163"/>
          <p:cNvSpPr/>
          <p:nvPr/>
        </p:nvSpPr>
        <p:spPr>
          <a:xfrm>
            <a:off x="1324080" y="2000160"/>
            <a:ext cx="3959280" cy="184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テキスト ボックス 167"/>
          <p:cNvSpPr/>
          <p:nvPr/>
        </p:nvSpPr>
        <p:spPr>
          <a:xfrm>
            <a:off x="1119240" y="2325600"/>
            <a:ext cx="47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テキスト ボックス 171"/>
          <p:cNvSpPr/>
          <p:nvPr/>
        </p:nvSpPr>
        <p:spPr>
          <a:xfrm>
            <a:off x="4959360" y="2362320"/>
            <a:ext cx="663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18</a:t>
            </a:r>
            <a:r>
              <a:rPr b="0" lang="ja-JP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テキスト ボックス 176"/>
          <p:cNvSpPr/>
          <p:nvPr/>
        </p:nvSpPr>
        <p:spPr>
          <a:xfrm>
            <a:off x="125280" y="1874880"/>
            <a:ext cx="70488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Pt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tri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テキスト ボックス 178"/>
          <p:cNvSpPr/>
          <p:nvPr/>
        </p:nvSpPr>
        <p:spPr>
          <a:xfrm>
            <a:off x="1009800" y="1954080"/>
            <a:ext cx="469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Rt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テキスト ボックス 179"/>
          <p:cNvSpPr/>
          <p:nvPr/>
        </p:nvSpPr>
        <p:spPr>
          <a:xfrm>
            <a:off x="1006560" y="2152800"/>
            <a:ext cx="3506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Lt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下矢印 185"/>
          <p:cNvSpPr/>
          <p:nvPr/>
        </p:nvSpPr>
        <p:spPr>
          <a:xfrm>
            <a:off x="1800360" y="5859360"/>
            <a:ext cx="101520" cy="7164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000000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テキスト ボックス 186"/>
          <p:cNvSpPr/>
          <p:nvPr/>
        </p:nvSpPr>
        <p:spPr>
          <a:xfrm>
            <a:off x="2998800" y="2347920"/>
            <a:ext cx="47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テキスト ボックス 197"/>
          <p:cNvSpPr/>
          <p:nvPr/>
        </p:nvSpPr>
        <p:spPr>
          <a:xfrm>
            <a:off x="1324080" y="2187720"/>
            <a:ext cx="3960720" cy="183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テキスト ボックス 208"/>
          <p:cNvSpPr/>
          <p:nvPr/>
        </p:nvSpPr>
        <p:spPr>
          <a:xfrm>
            <a:off x="1433520" y="1828800"/>
            <a:ext cx="3492360" cy="154080"/>
          </a:xfrm>
          <a:prstGeom prst="rect">
            <a:avLst/>
          </a:prstGeom>
          <a:solidFill>
            <a:srgbClr val="595959"/>
          </a:solidFill>
          <a:ln w="9360">
            <a:solidFill>
              <a:srgbClr val="5959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テキスト ボックス 211"/>
          <p:cNvSpPr/>
          <p:nvPr/>
        </p:nvSpPr>
        <p:spPr>
          <a:xfrm>
            <a:off x="1560600" y="1662120"/>
            <a:ext cx="828720" cy="154080"/>
          </a:xfrm>
          <a:prstGeom prst="rect">
            <a:avLst/>
          </a:prstGeom>
          <a:solidFill>
            <a:srgbClr val="afabab"/>
          </a:solidFill>
          <a:ln w="9360">
            <a:solidFill>
              <a:srgbClr val="afaba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テキスト ボックス 213"/>
          <p:cNvSpPr/>
          <p:nvPr/>
        </p:nvSpPr>
        <p:spPr>
          <a:xfrm>
            <a:off x="2824200" y="1541520"/>
            <a:ext cx="774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Regrowth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下矢印 214"/>
          <p:cNvSpPr/>
          <p:nvPr/>
        </p:nvSpPr>
        <p:spPr>
          <a:xfrm>
            <a:off x="3171960" y="1739880"/>
            <a:ext cx="104760" cy="7308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000000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280" bIns="82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テキスト ボックス 215"/>
          <p:cNvSpPr/>
          <p:nvPr/>
        </p:nvSpPr>
        <p:spPr>
          <a:xfrm>
            <a:off x="103320" y="2766960"/>
            <a:ext cx="822240" cy="79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Pt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bil.</a:t>
            </a:r>
            <a:r>
              <a:rPr b="1" lang="ja-JP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→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tri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テキスト ボックス 217"/>
          <p:cNvSpPr/>
          <p:nvPr/>
        </p:nvSpPr>
        <p:spPr>
          <a:xfrm>
            <a:off x="1146240" y="3186000"/>
            <a:ext cx="47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テキスト ボックス 218"/>
          <p:cNvSpPr/>
          <p:nvPr/>
        </p:nvSpPr>
        <p:spPr>
          <a:xfrm>
            <a:off x="5703840" y="3187800"/>
            <a:ext cx="58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23</a:t>
            </a:r>
            <a:r>
              <a:rPr b="0" lang="ja-JP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テキスト ボックス 224"/>
          <p:cNvSpPr/>
          <p:nvPr/>
        </p:nvSpPr>
        <p:spPr>
          <a:xfrm>
            <a:off x="1351080" y="2857680"/>
            <a:ext cx="222120" cy="183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テキスト ボックス 227"/>
          <p:cNvSpPr/>
          <p:nvPr/>
        </p:nvSpPr>
        <p:spPr>
          <a:xfrm>
            <a:off x="1052640" y="2790720"/>
            <a:ext cx="471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Rt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テキスト ボックス 228"/>
          <p:cNvSpPr/>
          <p:nvPr/>
        </p:nvSpPr>
        <p:spPr>
          <a:xfrm>
            <a:off x="1069920" y="2994120"/>
            <a:ext cx="47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Lt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テキスト ボックス 230"/>
          <p:cNvSpPr/>
          <p:nvPr/>
        </p:nvSpPr>
        <p:spPr>
          <a:xfrm>
            <a:off x="5459400" y="2705040"/>
            <a:ext cx="716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tri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下矢印 231"/>
          <p:cNvSpPr/>
          <p:nvPr/>
        </p:nvSpPr>
        <p:spPr>
          <a:xfrm>
            <a:off x="5767560" y="2936880"/>
            <a:ext cx="104760" cy="7308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000000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280" bIns="82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テキスト ボックス 232"/>
          <p:cNvSpPr/>
          <p:nvPr/>
        </p:nvSpPr>
        <p:spPr>
          <a:xfrm>
            <a:off x="2514600" y="3181320"/>
            <a:ext cx="480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テキスト ボックス 243"/>
          <p:cNvSpPr/>
          <p:nvPr/>
        </p:nvSpPr>
        <p:spPr>
          <a:xfrm>
            <a:off x="1363680" y="3832200"/>
            <a:ext cx="5221440" cy="184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テキスト ボックス 244"/>
          <p:cNvSpPr/>
          <p:nvPr/>
        </p:nvSpPr>
        <p:spPr>
          <a:xfrm>
            <a:off x="1158840" y="4135320"/>
            <a:ext cx="480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テキスト ボックス 245"/>
          <p:cNvSpPr/>
          <p:nvPr/>
        </p:nvSpPr>
        <p:spPr>
          <a:xfrm>
            <a:off x="6199200" y="4133880"/>
            <a:ext cx="55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27</a:t>
            </a:r>
            <a:r>
              <a:rPr b="0" lang="ja-JP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テキスト ボックス 247"/>
          <p:cNvSpPr/>
          <p:nvPr/>
        </p:nvSpPr>
        <p:spPr>
          <a:xfrm>
            <a:off x="112680" y="3706920"/>
            <a:ext cx="70488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Pt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uni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テキスト ボックス 248"/>
          <p:cNvSpPr/>
          <p:nvPr/>
        </p:nvSpPr>
        <p:spPr>
          <a:xfrm>
            <a:off x="1365120" y="4021200"/>
            <a:ext cx="220680" cy="183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テキスト ボックス 249"/>
          <p:cNvSpPr/>
          <p:nvPr/>
        </p:nvSpPr>
        <p:spPr>
          <a:xfrm>
            <a:off x="1066680" y="3786120"/>
            <a:ext cx="470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Rt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テキスト ボックス 250"/>
          <p:cNvSpPr/>
          <p:nvPr/>
        </p:nvSpPr>
        <p:spPr>
          <a:xfrm>
            <a:off x="1084320" y="3938760"/>
            <a:ext cx="469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Lt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テキスト ボックス 252"/>
          <p:cNvSpPr/>
          <p:nvPr/>
        </p:nvSpPr>
        <p:spPr>
          <a:xfrm>
            <a:off x="1430280" y="3581280"/>
            <a:ext cx="993960" cy="22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ts val="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BM invasio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下矢印 253"/>
          <p:cNvSpPr/>
          <p:nvPr/>
        </p:nvSpPr>
        <p:spPr>
          <a:xfrm>
            <a:off x="2014560" y="3743280"/>
            <a:ext cx="106200" cy="7308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000000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280" bIns="82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テキスト ボックス 254"/>
          <p:cNvSpPr/>
          <p:nvPr/>
        </p:nvSpPr>
        <p:spPr>
          <a:xfrm>
            <a:off x="1828800" y="4125960"/>
            <a:ext cx="480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テキスト ボックス 259"/>
          <p:cNvSpPr/>
          <p:nvPr/>
        </p:nvSpPr>
        <p:spPr>
          <a:xfrm>
            <a:off x="2367000" y="3503520"/>
            <a:ext cx="828720" cy="154080"/>
          </a:xfrm>
          <a:prstGeom prst="rect">
            <a:avLst/>
          </a:prstGeom>
          <a:solidFill>
            <a:srgbClr val="afabab"/>
          </a:solidFill>
          <a:ln w="9360">
            <a:solidFill>
              <a:srgbClr val="afaba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テキスト ボックス 262"/>
          <p:cNvSpPr/>
          <p:nvPr/>
        </p:nvSpPr>
        <p:spPr>
          <a:xfrm>
            <a:off x="2637000" y="3665520"/>
            <a:ext cx="3770280" cy="154080"/>
          </a:xfrm>
          <a:prstGeom prst="rect">
            <a:avLst/>
          </a:prstGeom>
          <a:solidFill>
            <a:srgbClr val="595959"/>
          </a:solidFill>
          <a:ln w="9360">
            <a:solidFill>
              <a:srgbClr val="5959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テキスト ボックス 267"/>
          <p:cNvSpPr/>
          <p:nvPr/>
        </p:nvSpPr>
        <p:spPr>
          <a:xfrm>
            <a:off x="1154160" y="5141880"/>
            <a:ext cx="480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テキスト ボックス 268"/>
          <p:cNvSpPr/>
          <p:nvPr/>
        </p:nvSpPr>
        <p:spPr>
          <a:xfrm>
            <a:off x="7488360" y="5154480"/>
            <a:ext cx="662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92 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テキスト ボックス 270"/>
          <p:cNvSpPr/>
          <p:nvPr/>
        </p:nvSpPr>
        <p:spPr>
          <a:xfrm>
            <a:off x="108000" y="4713120"/>
            <a:ext cx="97452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Pt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bil.</a:t>
            </a:r>
            <a:r>
              <a:rPr b="1" lang="ja-JP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→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C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テキスト ボックス 271"/>
          <p:cNvSpPr/>
          <p:nvPr/>
        </p:nvSpPr>
        <p:spPr>
          <a:xfrm>
            <a:off x="1363680" y="4834080"/>
            <a:ext cx="4321080" cy="183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テキスト ボックス 272"/>
          <p:cNvSpPr/>
          <p:nvPr/>
        </p:nvSpPr>
        <p:spPr>
          <a:xfrm>
            <a:off x="1062000" y="4800600"/>
            <a:ext cx="469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Rt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テキスト ボックス 273"/>
          <p:cNvSpPr/>
          <p:nvPr/>
        </p:nvSpPr>
        <p:spPr>
          <a:xfrm>
            <a:off x="1079640" y="4952880"/>
            <a:ext cx="471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Lt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下矢印 276"/>
          <p:cNvSpPr/>
          <p:nvPr/>
        </p:nvSpPr>
        <p:spPr>
          <a:xfrm>
            <a:off x="3981600" y="4745160"/>
            <a:ext cx="104760" cy="7128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6840" bIns="68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テキスト ボックス 277"/>
          <p:cNvSpPr/>
          <p:nvPr/>
        </p:nvSpPr>
        <p:spPr>
          <a:xfrm>
            <a:off x="3814920" y="5157720"/>
            <a:ext cx="480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3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テキスト ボックス 279"/>
          <p:cNvSpPr/>
          <p:nvPr/>
        </p:nvSpPr>
        <p:spPr>
          <a:xfrm>
            <a:off x="2265480" y="4856040"/>
            <a:ext cx="1212840" cy="154080"/>
          </a:xfrm>
          <a:prstGeom prst="rect">
            <a:avLst/>
          </a:prstGeom>
          <a:solidFill>
            <a:srgbClr val="d6dce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テキスト ボックス 282"/>
          <p:cNvSpPr/>
          <p:nvPr/>
        </p:nvSpPr>
        <p:spPr>
          <a:xfrm>
            <a:off x="1384200" y="4667400"/>
            <a:ext cx="828720" cy="153720"/>
          </a:xfrm>
          <a:prstGeom prst="rect">
            <a:avLst/>
          </a:prstGeom>
          <a:solidFill>
            <a:srgbClr val="afabab"/>
          </a:solidFill>
          <a:ln w="9360">
            <a:solidFill>
              <a:srgbClr val="afaba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テキスト ボックス 285"/>
          <p:cNvSpPr/>
          <p:nvPr/>
        </p:nvSpPr>
        <p:spPr>
          <a:xfrm>
            <a:off x="3052800" y="4651200"/>
            <a:ext cx="615960" cy="154080"/>
          </a:xfrm>
          <a:prstGeom prst="rect">
            <a:avLst/>
          </a:prstGeom>
          <a:solidFill>
            <a:srgbClr val="595959"/>
          </a:solidFill>
          <a:ln w="9360">
            <a:solidFill>
              <a:srgbClr val="5959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テキスト ボックス 288"/>
          <p:cNvSpPr/>
          <p:nvPr/>
        </p:nvSpPr>
        <p:spPr>
          <a:xfrm>
            <a:off x="2249640" y="5037120"/>
            <a:ext cx="664920" cy="154080"/>
          </a:xfrm>
          <a:prstGeom prst="rect">
            <a:avLst/>
          </a:prstGeom>
          <a:solidFill>
            <a:srgbClr val="d6dce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テキスト ボックス 292"/>
          <p:cNvSpPr/>
          <p:nvPr/>
        </p:nvSpPr>
        <p:spPr>
          <a:xfrm>
            <a:off x="4332240" y="4664160"/>
            <a:ext cx="463680" cy="154080"/>
          </a:xfrm>
          <a:prstGeom prst="rect">
            <a:avLst/>
          </a:prstGeom>
          <a:solidFill>
            <a:srgbClr val="afabab"/>
          </a:solidFill>
          <a:ln w="9360">
            <a:solidFill>
              <a:srgbClr val="afaba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テキスト ボックス 295"/>
          <p:cNvSpPr/>
          <p:nvPr/>
        </p:nvSpPr>
        <p:spPr>
          <a:xfrm>
            <a:off x="4967280" y="4851360"/>
            <a:ext cx="520560" cy="154080"/>
          </a:xfrm>
          <a:prstGeom prst="rect">
            <a:avLst/>
          </a:prstGeom>
          <a:solidFill>
            <a:srgbClr val="d6dce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テキスト ボックス 298"/>
          <p:cNvSpPr/>
          <p:nvPr/>
        </p:nvSpPr>
        <p:spPr>
          <a:xfrm>
            <a:off x="5802480" y="4670280"/>
            <a:ext cx="1199880" cy="154080"/>
          </a:xfrm>
          <a:prstGeom prst="rect">
            <a:avLst/>
          </a:prstGeom>
          <a:solidFill>
            <a:srgbClr val="595959"/>
          </a:solidFill>
          <a:ln w="9360">
            <a:solidFill>
              <a:srgbClr val="5959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テキスト ボックス 301"/>
          <p:cNvSpPr/>
          <p:nvPr/>
        </p:nvSpPr>
        <p:spPr>
          <a:xfrm>
            <a:off x="7089840" y="4667400"/>
            <a:ext cx="463320" cy="153720"/>
          </a:xfrm>
          <a:prstGeom prst="rect">
            <a:avLst/>
          </a:prstGeom>
          <a:solidFill>
            <a:srgbClr val="afabab"/>
          </a:solidFill>
          <a:ln w="9360">
            <a:solidFill>
              <a:srgbClr val="afaba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フリーフォーム 307"/>
          <p:cNvSpPr/>
          <p:nvPr/>
        </p:nvSpPr>
        <p:spPr>
          <a:xfrm rot="5400000">
            <a:off x="6238800" y="5070600"/>
            <a:ext cx="573120" cy="217440"/>
          </a:xfrm>
          <a:custGeom>
            <a:avLst/>
            <a:gdLst/>
            <a:ahLst/>
            <a:rect l="l" t="t" r="r" b="b"/>
            <a:pathLst>
              <a:path w="2156346" h="436823">
                <a:moveTo>
                  <a:pt x="0" y="423090"/>
                </a:moveTo>
                <a:cubicBezTo>
                  <a:pt x="118280" y="225197"/>
                  <a:pt x="236561" y="27305"/>
                  <a:pt x="354842" y="27305"/>
                </a:cubicBezTo>
                <a:cubicBezTo>
                  <a:pt x="473123" y="27305"/>
                  <a:pt x="589129" y="427639"/>
                  <a:pt x="709684" y="423090"/>
                </a:cubicBezTo>
                <a:cubicBezTo>
                  <a:pt x="830239" y="418541"/>
                  <a:pt x="957618" y="-2265"/>
                  <a:pt x="1078173" y="9"/>
                </a:cubicBezTo>
                <a:cubicBezTo>
                  <a:pt x="1198728" y="2283"/>
                  <a:pt x="1310185" y="429913"/>
                  <a:pt x="1433015" y="436737"/>
                </a:cubicBezTo>
                <a:cubicBezTo>
                  <a:pt x="1555845" y="443561"/>
                  <a:pt x="1694597" y="43226"/>
                  <a:pt x="1815152" y="40952"/>
                </a:cubicBezTo>
                <a:cubicBezTo>
                  <a:pt x="1935707" y="38678"/>
                  <a:pt x="2156346" y="423090"/>
                  <a:pt x="2156346" y="423090"/>
                </a:cubicBezTo>
                <a:lnTo>
                  <a:pt x="2156346" y="423090"/>
                </a:ln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フリーフォーム 308"/>
          <p:cNvSpPr/>
          <p:nvPr/>
        </p:nvSpPr>
        <p:spPr>
          <a:xfrm rot="5400000">
            <a:off x="6480360" y="5058360"/>
            <a:ext cx="573120" cy="219240"/>
          </a:xfrm>
          <a:custGeom>
            <a:avLst/>
            <a:gdLst/>
            <a:ahLst/>
            <a:rect l="l" t="t" r="r" b="b"/>
            <a:pathLst>
              <a:path w="2156346" h="436823">
                <a:moveTo>
                  <a:pt x="0" y="423090"/>
                </a:moveTo>
                <a:cubicBezTo>
                  <a:pt x="118280" y="225197"/>
                  <a:pt x="236561" y="27305"/>
                  <a:pt x="354842" y="27305"/>
                </a:cubicBezTo>
                <a:cubicBezTo>
                  <a:pt x="473123" y="27305"/>
                  <a:pt x="589129" y="427639"/>
                  <a:pt x="709684" y="423090"/>
                </a:cubicBezTo>
                <a:cubicBezTo>
                  <a:pt x="830239" y="418541"/>
                  <a:pt x="957618" y="-2265"/>
                  <a:pt x="1078173" y="9"/>
                </a:cubicBezTo>
                <a:cubicBezTo>
                  <a:pt x="1198728" y="2283"/>
                  <a:pt x="1310185" y="429913"/>
                  <a:pt x="1433015" y="436737"/>
                </a:cubicBezTo>
                <a:cubicBezTo>
                  <a:pt x="1555845" y="443561"/>
                  <a:pt x="1694597" y="43226"/>
                  <a:pt x="1815152" y="40952"/>
                </a:cubicBezTo>
                <a:cubicBezTo>
                  <a:pt x="1935707" y="38678"/>
                  <a:pt x="2156346" y="423090"/>
                  <a:pt x="2156346" y="423090"/>
                </a:cubicBezTo>
                <a:lnTo>
                  <a:pt x="2156346" y="423090"/>
                </a:ln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テキスト ボックス 123"/>
          <p:cNvSpPr/>
          <p:nvPr/>
        </p:nvSpPr>
        <p:spPr>
          <a:xfrm>
            <a:off x="95400" y="5518080"/>
            <a:ext cx="1038240" cy="79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Pt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bil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→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SP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テキスト ボックス 124"/>
          <p:cNvSpPr/>
          <p:nvPr/>
        </p:nvSpPr>
        <p:spPr>
          <a:xfrm>
            <a:off x="1338120" y="6099120"/>
            <a:ext cx="7631280" cy="184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テキスト ボックス 125"/>
          <p:cNvSpPr/>
          <p:nvPr/>
        </p:nvSpPr>
        <p:spPr>
          <a:xfrm>
            <a:off x="1133640" y="6243480"/>
            <a:ext cx="479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テキスト ボックス 127"/>
          <p:cNvSpPr/>
          <p:nvPr/>
        </p:nvSpPr>
        <p:spPr>
          <a:xfrm>
            <a:off x="1039680" y="5886360"/>
            <a:ext cx="47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Rt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テキスト ボックス 128"/>
          <p:cNvSpPr/>
          <p:nvPr/>
        </p:nvSpPr>
        <p:spPr>
          <a:xfrm>
            <a:off x="1057320" y="6039000"/>
            <a:ext cx="47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Lt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テキスト ボックス 133"/>
          <p:cNvSpPr/>
          <p:nvPr/>
        </p:nvSpPr>
        <p:spPr>
          <a:xfrm>
            <a:off x="2308320" y="5635800"/>
            <a:ext cx="828720" cy="153720"/>
          </a:xfrm>
          <a:prstGeom prst="rect">
            <a:avLst/>
          </a:prstGeom>
          <a:solidFill>
            <a:srgbClr val="afabab"/>
          </a:solidFill>
          <a:ln w="9360">
            <a:solidFill>
              <a:srgbClr val="afaba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テキスト ボックス 126"/>
          <p:cNvSpPr/>
          <p:nvPr/>
        </p:nvSpPr>
        <p:spPr>
          <a:xfrm>
            <a:off x="1347840" y="5915160"/>
            <a:ext cx="220680" cy="185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テキスト ボックス 140"/>
          <p:cNvSpPr/>
          <p:nvPr/>
        </p:nvSpPr>
        <p:spPr>
          <a:xfrm>
            <a:off x="1596960" y="6232680"/>
            <a:ext cx="47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フリーフォーム 308"/>
          <p:cNvSpPr/>
          <p:nvPr/>
        </p:nvSpPr>
        <p:spPr>
          <a:xfrm rot="5400000">
            <a:off x="3347280" y="6170040"/>
            <a:ext cx="573120" cy="218880"/>
          </a:xfrm>
          <a:custGeom>
            <a:avLst/>
            <a:gdLst/>
            <a:ahLst/>
            <a:rect l="l" t="t" r="r" b="b"/>
            <a:pathLst>
              <a:path w="2156346" h="436823">
                <a:moveTo>
                  <a:pt x="0" y="423090"/>
                </a:moveTo>
                <a:cubicBezTo>
                  <a:pt x="118280" y="225197"/>
                  <a:pt x="236561" y="27305"/>
                  <a:pt x="354842" y="27305"/>
                </a:cubicBezTo>
                <a:cubicBezTo>
                  <a:pt x="473123" y="27305"/>
                  <a:pt x="589129" y="427639"/>
                  <a:pt x="709684" y="423090"/>
                </a:cubicBezTo>
                <a:cubicBezTo>
                  <a:pt x="830239" y="418541"/>
                  <a:pt x="957618" y="-2265"/>
                  <a:pt x="1078173" y="9"/>
                </a:cubicBezTo>
                <a:cubicBezTo>
                  <a:pt x="1198728" y="2283"/>
                  <a:pt x="1310185" y="429913"/>
                  <a:pt x="1433015" y="436737"/>
                </a:cubicBezTo>
                <a:cubicBezTo>
                  <a:pt x="1555845" y="443561"/>
                  <a:pt x="1694597" y="43226"/>
                  <a:pt x="1815152" y="40952"/>
                </a:cubicBezTo>
                <a:cubicBezTo>
                  <a:pt x="1935707" y="38678"/>
                  <a:pt x="2156346" y="423090"/>
                  <a:pt x="2156346" y="423090"/>
                </a:cubicBezTo>
                <a:lnTo>
                  <a:pt x="2156346" y="423090"/>
                </a:ln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フリーフォーム 308"/>
          <p:cNvSpPr/>
          <p:nvPr/>
        </p:nvSpPr>
        <p:spPr>
          <a:xfrm rot="5400000">
            <a:off x="3588480" y="6170040"/>
            <a:ext cx="573120" cy="218880"/>
          </a:xfrm>
          <a:custGeom>
            <a:avLst/>
            <a:gdLst/>
            <a:ahLst/>
            <a:rect l="l" t="t" r="r" b="b"/>
            <a:pathLst>
              <a:path w="2156346" h="436823">
                <a:moveTo>
                  <a:pt x="0" y="423090"/>
                </a:moveTo>
                <a:cubicBezTo>
                  <a:pt x="118280" y="225197"/>
                  <a:pt x="236561" y="27305"/>
                  <a:pt x="354842" y="27305"/>
                </a:cubicBezTo>
                <a:cubicBezTo>
                  <a:pt x="473123" y="27305"/>
                  <a:pt x="589129" y="427639"/>
                  <a:pt x="709684" y="423090"/>
                </a:cubicBezTo>
                <a:cubicBezTo>
                  <a:pt x="830239" y="418541"/>
                  <a:pt x="957618" y="-2265"/>
                  <a:pt x="1078173" y="9"/>
                </a:cubicBezTo>
                <a:cubicBezTo>
                  <a:pt x="1198728" y="2283"/>
                  <a:pt x="1310185" y="429913"/>
                  <a:pt x="1433015" y="436737"/>
                </a:cubicBezTo>
                <a:cubicBezTo>
                  <a:pt x="1555845" y="443561"/>
                  <a:pt x="1694597" y="43226"/>
                  <a:pt x="1815152" y="40952"/>
                </a:cubicBezTo>
                <a:cubicBezTo>
                  <a:pt x="1935707" y="38678"/>
                  <a:pt x="2156346" y="423090"/>
                  <a:pt x="2156346" y="423090"/>
                </a:cubicBezTo>
                <a:lnTo>
                  <a:pt x="2156346" y="423090"/>
                </a:ln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下矢印 276"/>
          <p:cNvSpPr/>
          <p:nvPr/>
        </p:nvSpPr>
        <p:spPr>
          <a:xfrm>
            <a:off x="4105440" y="5865840"/>
            <a:ext cx="104760" cy="71280"/>
          </a:xfrm>
          <a:prstGeom prst="downArrow">
            <a:avLst>
              <a:gd name="adj1" fmla="val 50000"/>
              <a:gd name="adj2" fmla="val 50000"/>
            </a:avLst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6840" bIns="68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テキスト ボックス 144"/>
          <p:cNvSpPr/>
          <p:nvPr/>
        </p:nvSpPr>
        <p:spPr>
          <a:xfrm>
            <a:off x="3967200" y="5900760"/>
            <a:ext cx="1012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Osteosarcom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テキスト ボックス 145"/>
          <p:cNvSpPr/>
          <p:nvPr/>
        </p:nvSpPr>
        <p:spPr>
          <a:xfrm>
            <a:off x="3919680" y="6251400"/>
            <a:ext cx="502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22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テキスト ボックス 150"/>
          <p:cNvSpPr/>
          <p:nvPr/>
        </p:nvSpPr>
        <p:spPr>
          <a:xfrm>
            <a:off x="4390920" y="5775480"/>
            <a:ext cx="615960" cy="153720"/>
          </a:xfrm>
          <a:prstGeom prst="rect">
            <a:avLst/>
          </a:prstGeom>
          <a:solidFill>
            <a:srgbClr val="595959"/>
          </a:solidFill>
          <a:ln w="9360">
            <a:solidFill>
              <a:srgbClr val="5959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テキスト ボックス 158"/>
          <p:cNvSpPr/>
          <p:nvPr/>
        </p:nvSpPr>
        <p:spPr>
          <a:xfrm>
            <a:off x="5187960" y="5783400"/>
            <a:ext cx="617400" cy="153720"/>
          </a:xfrm>
          <a:prstGeom prst="rect">
            <a:avLst/>
          </a:prstGeom>
          <a:solidFill>
            <a:srgbClr val="595959"/>
          </a:solidFill>
          <a:ln w="9360">
            <a:solidFill>
              <a:srgbClr val="5959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テキスト ボックス 161"/>
          <p:cNvSpPr/>
          <p:nvPr/>
        </p:nvSpPr>
        <p:spPr>
          <a:xfrm>
            <a:off x="5402160" y="5915160"/>
            <a:ext cx="1255680" cy="22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ts val="9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lung metastas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テキスト ボックス 166"/>
          <p:cNvSpPr/>
          <p:nvPr/>
        </p:nvSpPr>
        <p:spPr>
          <a:xfrm>
            <a:off x="6404040" y="5780160"/>
            <a:ext cx="463320" cy="154080"/>
          </a:xfrm>
          <a:prstGeom prst="rect">
            <a:avLst/>
          </a:prstGeom>
          <a:solidFill>
            <a:srgbClr val="afabab"/>
          </a:solidFill>
          <a:ln w="9360">
            <a:solidFill>
              <a:srgbClr val="afaba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下矢印 276"/>
          <p:cNvSpPr/>
          <p:nvPr/>
        </p:nvSpPr>
        <p:spPr>
          <a:xfrm>
            <a:off x="5970600" y="5856120"/>
            <a:ext cx="104760" cy="71640"/>
          </a:xfrm>
          <a:prstGeom prst="downArrow">
            <a:avLst>
              <a:gd name="adj1" fmla="val 50000"/>
              <a:gd name="adj2" fmla="val 50000"/>
            </a:avLst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テキスト ボックス 173"/>
          <p:cNvSpPr/>
          <p:nvPr/>
        </p:nvSpPr>
        <p:spPr>
          <a:xfrm>
            <a:off x="6916680" y="5783400"/>
            <a:ext cx="617760" cy="153720"/>
          </a:xfrm>
          <a:prstGeom prst="rect">
            <a:avLst/>
          </a:prstGeom>
          <a:solidFill>
            <a:srgbClr val="595959"/>
          </a:solidFill>
          <a:ln w="9360">
            <a:solidFill>
              <a:srgbClr val="5959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テキスト ボックス 175"/>
          <p:cNvSpPr/>
          <p:nvPr/>
        </p:nvSpPr>
        <p:spPr>
          <a:xfrm>
            <a:off x="8385120" y="6243480"/>
            <a:ext cx="652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290</a:t>
            </a:r>
            <a:r>
              <a:rPr b="0" lang="ja-JP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テキスト ボックス 182"/>
          <p:cNvSpPr/>
          <p:nvPr/>
        </p:nvSpPr>
        <p:spPr>
          <a:xfrm>
            <a:off x="2959200" y="6121440"/>
            <a:ext cx="519120" cy="154080"/>
          </a:xfrm>
          <a:prstGeom prst="rect">
            <a:avLst/>
          </a:prstGeom>
          <a:solidFill>
            <a:srgbClr val="d6dce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テキスト ボックス 184"/>
          <p:cNvSpPr/>
          <p:nvPr/>
        </p:nvSpPr>
        <p:spPr>
          <a:xfrm>
            <a:off x="5477040" y="5145120"/>
            <a:ext cx="43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5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テキスト ボックス 164"/>
          <p:cNvSpPr/>
          <p:nvPr/>
        </p:nvSpPr>
        <p:spPr>
          <a:xfrm>
            <a:off x="3137040" y="649440"/>
            <a:ext cx="47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Ra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テキスト ボックス 187"/>
          <p:cNvSpPr/>
          <p:nvPr/>
        </p:nvSpPr>
        <p:spPr>
          <a:xfrm>
            <a:off x="2205000" y="1747800"/>
            <a:ext cx="871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Chemo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テキスト ボックス 188"/>
          <p:cNvSpPr/>
          <p:nvPr/>
        </p:nvSpPr>
        <p:spPr>
          <a:xfrm>
            <a:off x="1711440" y="1585800"/>
            <a:ext cx="47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Ra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テキスト ボックス 189"/>
          <p:cNvSpPr/>
          <p:nvPr/>
        </p:nvSpPr>
        <p:spPr>
          <a:xfrm>
            <a:off x="2851200" y="2987640"/>
            <a:ext cx="663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Loca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テキスト ボックス 190"/>
          <p:cNvSpPr/>
          <p:nvPr/>
        </p:nvSpPr>
        <p:spPr>
          <a:xfrm>
            <a:off x="1760400" y="2627280"/>
            <a:ext cx="47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Ra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テキスト ボックス 191"/>
          <p:cNvSpPr/>
          <p:nvPr/>
        </p:nvSpPr>
        <p:spPr>
          <a:xfrm>
            <a:off x="3008160" y="3594240"/>
            <a:ext cx="871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Chemo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テキスト ボックス 192"/>
          <p:cNvSpPr/>
          <p:nvPr/>
        </p:nvSpPr>
        <p:spPr>
          <a:xfrm>
            <a:off x="2513160" y="3422520"/>
            <a:ext cx="47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Ra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テキスト ボックス 193"/>
          <p:cNvSpPr/>
          <p:nvPr/>
        </p:nvSpPr>
        <p:spPr>
          <a:xfrm>
            <a:off x="1544760" y="4594320"/>
            <a:ext cx="47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Ra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テキスト ボックス 194"/>
          <p:cNvSpPr/>
          <p:nvPr/>
        </p:nvSpPr>
        <p:spPr>
          <a:xfrm>
            <a:off x="4319640" y="4581360"/>
            <a:ext cx="47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Ra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テキスト ボックス 195"/>
          <p:cNvSpPr/>
          <p:nvPr/>
        </p:nvSpPr>
        <p:spPr>
          <a:xfrm>
            <a:off x="7112160" y="4595760"/>
            <a:ext cx="47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Ra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テキスト ボックス 196"/>
          <p:cNvSpPr/>
          <p:nvPr/>
        </p:nvSpPr>
        <p:spPr>
          <a:xfrm>
            <a:off x="2562120" y="4788000"/>
            <a:ext cx="66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Loca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テキスト ボックス 198"/>
          <p:cNvSpPr/>
          <p:nvPr/>
        </p:nvSpPr>
        <p:spPr>
          <a:xfrm>
            <a:off x="2352600" y="4965840"/>
            <a:ext cx="66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Loca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テキスト ボックス 199"/>
          <p:cNvSpPr/>
          <p:nvPr/>
        </p:nvSpPr>
        <p:spPr>
          <a:xfrm>
            <a:off x="4957920" y="4784760"/>
            <a:ext cx="664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Loca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テキスト ボックス 200"/>
          <p:cNvSpPr/>
          <p:nvPr/>
        </p:nvSpPr>
        <p:spPr>
          <a:xfrm>
            <a:off x="2498760" y="5556240"/>
            <a:ext cx="47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Ra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テキスト ボックス 201"/>
          <p:cNvSpPr/>
          <p:nvPr/>
        </p:nvSpPr>
        <p:spPr>
          <a:xfrm>
            <a:off x="6407280" y="5703840"/>
            <a:ext cx="47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Ra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テキスト ボックス 202"/>
          <p:cNvSpPr/>
          <p:nvPr/>
        </p:nvSpPr>
        <p:spPr>
          <a:xfrm>
            <a:off x="6053040" y="4594320"/>
            <a:ext cx="871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Chemo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テキスト ボックス 203"/>
          <p:cNvSpPr/>
          <p:nvPr/>
        </p:nvSpPr>
        <p:spPr>
          <a:xfrm>
            <a:off x="2997360" y="4575240"/>
            <a:ext cx="869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Chemo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テキスト ボックス 204"/>
          <p:cNvSpPr/>
          <p:nvPr/>
        </p:nvSpPr>
        <p:spPr>
          <a:xfrm>
            <a:off x="4349880" y="5702400"/>
            <a:ext cx="871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Chemo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テキスト ボックス 205"/>
          <p:cNvSpPr/>
          <p:nvPr/>
        </p:nvSpPr>
        <p:spPr>
          <a:xfrm>
            <a:off x="4964040" y="5659560"/>
            <a:ext cx="27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HG丸ｺﾞｼｯｸM-PRO"/>
                <a:ea typeface="HG丸ｺﾞｼｯｸM-PRO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テキスト ボックス 118"/>
          <p:cNvSpPr/>
          <p:nvPr/>
        </p:nvSpPr>
        <p:spPr>
          <a:xfrm>
            <a:off x="217440" y="128520"/>
            <a:ext cx="14050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17928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Calibri"/>
                <a:ea typeface="Times New Roman"/>
              </a:rPr>
              <a:t>Fig. S2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テキスト ボックス 119"/>
          <p:cNvSpPr/>
          <p:nvPr/>
        </p:nvSpPr>
        <p:spPr>
          <a:xfrm>
            <a:off x="2930400" y="6053040"/>
            <a:ext cx="663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Loca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テキスト ボックス 120"/>
          <p:cNvSpPr/>
          <p:nvPr/>
        </p:nvSpPr>
        <p:spPr>
          <a:xfrm>
            <a:off x="5154480" y="5703840"/>
            <a:ext cx="871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Chemo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テキスト ボックス 121"/>
          <p:cNvSpPr/>
          <p:nvPr/>
        </p:nvSpPr>
        <p:spPr>
          <a:xfrm>
            <a:off x="6894360" y="5699160"/>
            <a:ext cx="871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Calibri"/>
                <a:ea typeface="Times New Roman"/>
              </a:rPr>
              <a:t>Chemo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テキスト ボックス 122"/>
          <p:cNvSpPr/>
          <p:nvPr/>
        </p:nvSpPr>
        <p:spPr>
          <a:xfrm>
            <a:off x="4724280" y="5576760"/>
            <a:ext cx="793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Surgery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3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2-03T15:30:09Z</dcterms:created>
  <dc:creator>河野圭希</dc:creator>
  <dc:description/>
  <dc:language>en-US</dc:language>
  <cp:lastModifiedBy>Aguilar, Andrew Wervone</cp:lastModifiedBy>
  <cp:lastPrinted>2019-09-23T22:46:32Z</cp:lastPrinted>
  <dcterms:modified xsi:type="dcterms:W3CDTF">2020-01-21T04:57:44Z</dcterms:modified>
  <cp:revision>773</cp:revision>
  <dc:subject/>
  <dc:title>PowerPoint プレゼンテーション</dc:title>
</cp:coreProperties>
</file>